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326" r:id="rId3"/>
    <p:sldId id="322" r:id="rId4"/>
    <p:sldId id="321" r:id="rId5"/>
    <p:sldId id="328" r:id="rId6"/>
    <p:sldId id="332" r:id="rId7"/>
    <p:sldId id="330" r:id="rId8"/>
    <p:sldId id="314" r:id="rId9"/>
    <p:sldId id="335" r:id="rId10"/>
    <p:sldId id="334" r:id="rId11"/>
    <p:sldId id="333" r:id="rId12"/>
    <p:sldId id="313" r:id="rId13"/>
    <p:sldId id="336" r:id="rId14"/>
  </p:sldIdLst>
  <p:sldSz cx="12192000" cy="6858000"/>
  <p:notesSz cx="6797675" cy="992663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1185;&#30740;&#30456;&#20851;\&#32784;&#30416;&#21697;&#31995;&#31579;&#36873;\&#27700;&#22521;\&#38048;&#38078;&#21547;&#37327;&#27979;&#23450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1185;&#30740;&#30456;&#20851;\&#32784;&#30416;&#21697;&#31995;&#31579;&#36873;\&#27700;&#22521;\&#38048;&#38078;&#21547;&#37327;&#27979;&#23450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T$14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T$19:$T$20</c:f>
                <c:numCache>
                  <c:formatCode>General</c:formatCode>
                  <c:ptCount val="2"/>
                  <c:pt idx="0">
                    <c:v>7.3781772816868305E-2</c:v>
                  </c:pt>
                  <c:pt idx="1">
                    <c:v>0.44249999999999901</c:v>
                  </c:pt>
                </c:numCache>
              </c:numRef>
            </c:plus>
            <c:minus>
              <c:numRef>
                <c:f>Sheet2!$T$19:$T$20</c:f>
                <c:numCache>
                  <c:formatCode>General</c:formatCode>
                  <c:ptCount val="2"/>
                  <c:pt idx="0">
                    <c:v>7.3781772816868305E-2</c:v>
                  </c:pt>
                  <c:pt idx="1">
                    <c:v>0.442499999999999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S$15:$S$16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T$15:$T$16</c:f>
              <c:numCache>
                <c:formatCode>General</c:formatCode>
                <c:ptCount val="2"/>
                <c:pt idx="0">
                  <c:v>1.655</c:v>
                </c:pt>
                <c:pt idx="1">
                  <c:v>31.6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2C-4977-BE01-058564C50EF4}"/>
            </c:ext>
          </c:extLst>
        </c:ser>
        <c:ser>
          <c:idx val="1"/>
          <c:order val="1"/>
          <c:tx>
            <c:strRef>
              <c:f>Sheet2!$U$14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S$15:$S$16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U$15:$U$16</c:f>
              <c:numCache>
                <c:formatCode>General</c:formatCode>
                <c:ptCount val="2"/>
                <c:pt idx="0">
                  <c:v>1.665</c:v>
                </c:pt>
                <c:pt idx="1">
                  <c:v>16.2591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32C-4977-BE01-058564C50E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20778576"/>
        <c:axId val="920782896"/>
      </c:barChart>
      <c:catAx>
        <c:axId val="920778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82896"/>
        <c:crosses val="autoZero"/>
        <c:auto val="1"/>
        <c:lblAlgn val="ctr"/>
        <c:lblOffset val="100"/>
        <c:noMultiLvlLbl val="0"/>
      </c:catAx>
      <c:valAx>
        <c:axId val="920782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78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73072380543176"/>
          <c:y val="4.0652178477690287E-2"/>
          <c:w val="0.19339204036493085"/>
          <c:h val="9.00006299212598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4CL-1'!$R$19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4CL-1'!$T$20:$T$24</c:f>
                <c:numCache>
                  <c:formatCode>General</c:formatCode>
                  <c:ptCount val="5"/>
                  <c:pt idx="0">
                    <c:v>5.2093289882219361E-2</c:v>
                  </c:pt>
                  <c:pt idx="1">
                    <c:v>0.10493499512508961</c:v>
                  </c:pt>
                  <c:pt idx="2">
                    <c:v>0.26418951519701284</c:v>
                  </c:pt>
                  <c:pt idx="3">
                    <c:v>0.28937806449592257</c:v>
                  </c:pt>
                  <c:pt idx="4">
                    <c:v>0.4297033345077601</c:v>
                  </c:pt>
                </c:numCache>
              </c:numRef>
            </c:plus>
            <c:minus>
              <c:numRef>
                <c:f>'4CL-1'!$T$20:$T$24</c:f>
                <c:numCache>
                  <c:formatCode>General</c:formatCode>
                  <c:ptCount val="5"/>
                  <c:pt idx="0">
                    <c:v>5.2093289882219361E-2</c:v>
                  </c:pt>
                  <c:pt idx="1">
                    <c:v>0.10493499512508961</c:v>
                  </c:pt>
                  <c:pt idx="2">
                    <c:v>0.26418951519701284</c:v>
                  </c:pt>
                  <c:pt idx="3">
                    <c:v>0.28937806449592257</c:v>
                  </c:pt>
                  <c:pt idx="4">
                    <c:v>0.42970333450776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4CL-1'!$Q$20:$Q$24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'4CL-1'!$R$20:$R$24</c:f>
              <c:numCache>
                <c:formatCode>General</c:formatCode>
                <c:ptCount val="5"/>
                <c:pt idx="0">
                  <c:v>1.0009099601351272</c:v>
                </c:pt>
                <c:pt idx="1">
                  <c:v>1.4564329196814345</c:v>
                </c:pt>
                <c:pt idx="2">
                  <c:v>2.5287613554910671</c:v>
                </c:pt>
                <c:pt idx="3">
                  <c:v>2.9986899427325659</c:v>
                </c:pt>
                <c:pt idx="4">
                  <c:v>5.1224657540761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F47-4242-B7C3-2A6E5FBD0E9B}"/>
            </c:ext>
          </c:extLst>
        </c:ser>
        <c:ser>
          <c:idx val="1"/>
          <c:order val="1"/>
          <c:tx>
            <c:strRef>
              <c:f>'4CL-1'!$S$19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4CL-1'!$U$20:$U$24</c:f>
                <c:numCache>
                  <c:formatCode>General</c:formatCode>
                  <c:ptCount val="5"/>
                  <c:pt idx="0">
                    <c:v>7.3358685538787632E-2</c:v>
                  </c:pt>
                  <c:pt idx="1">
                    <c:v>0.12848768758532875</c:v>
                  </c:pt>
                  <c:pt idx="2">
                    <c:v>0.35245724724398159</c:v>
                  </c:pt>
                  <c:pt idx="3">
                    <c:v>0.29932116523460534</c:v>
                  </c:pt>
                  <c:pt idx="4">
                    <c:v>0.68299700800104357</c:v>
                  </c:pt>
                </c:numCache>
              </c:numRef>
            </c:plus>
            <c:minus>
              <c:numRef>
                <c:f>'4CL-1'!$U$20:$U$24</c:f>
                <c:numCache>
                  <c:formatCode>General</c:formatCode>
                  <c:ptCount val="5"/>
                  <c:pt idx="0">
                    <c:v>7.3358685538787632E-2</c:v>
                  </c:pt>
                  <c:pt idx="1">
                    <c:v>0.12848768758532875</c:v>
                  </c:pt>
                  <c:pt idx="2">
                    <c:v>0.35245724724398159</c:v>
                  </c:pt>
                  <c:pt idx="3">
                    <c:v>0.29932116523460534</c:v>
                  </c:pt>
                  <c:pt idx="4">
                    <c:v>0.682997008001043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4CL-1'!$Q$20:$Q$24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'4CL-1'!$S$20:$S$24</c:f>
              <c:numCache>
                <c:formatCode>General</c:formatCode>
                <c:ptCount val="5"/>
                <c:pt idx="0">
                  <c:v>1.0018394548768732</c:v>
                </c:pt>
                <c:pt idx="1">
                  <c:v>1.7726854059143207</c:v>
                </c:pt>
                <c:pt idx="2">
                  <c:v>3.9734650695134683</c:v>
                </c:pt>
                <c:pt idx="3">
                  <c:v>6.4178443213612555</c:v>
                </c:pt>
                <c:pt idx="4">
                  <c:v>8.45558655642194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F47-4242-B7C3-2A6E5FBD0E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  <c:max val="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214564070172977"/>
          <c:y val="7.7369017221499525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YB1-1'!$P$22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B1'!$Y$43:$Y$47</c:f>
                <c:numCache>
                  <c:formatCode>General</c:formatCode>
                  <c:ptCount val="5"/>
                  <c:pt idx="0">
                    <c:v>3.9737752996594614E-2</c:v>
                  </c:pt>
                  <c:pt idx="1">
                    <c:v>0.46469578902818937</c:v>
                  </c:pt>
                  <c:pt idx="2">
                    <c:v>0.3237060371065712</c:v>
                  </c:pt>
                  <c:pt idx="3">
                    <c:v>0.9438584875512066</c:v>
                  </c:pt>
                  <c:pt idx="4">
                    <c:v>0.34718329284665267</c:v>
                  </c:pt>
                </c:numCache>
              </c:numRef>
            </c:plus>
            <c:minus>
              <c:numRef>
                <c:f>'MYB1'!$Y$43:$Y$47</c:f>
                <c:numCache>
                  <c:formatCode>General</c:formatCode>
                  <c:ptCount val="5"/>
                  <c:pt idx="0">
                    <c:v>3.9737752996594614E-2</c:v>
                  </c:pt>
                  <c:pt idx="1">
                    <c:v>0.46469578902818937</c:v>
                  </c:pt>
                  <c:pt idx="2">
                    <c:v>0.3237060371065712</c:v>
                  </c:pt>
                  <c:pt idx="3">
                    <c:v>0.9438584875512066</c:v>
                  </c:pt>
                  <c:pt idx="4">
                    <c:v>0.347183292846652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B1-1'!$O$23:$O$27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'MYB1-1'!$P$23:$P$27</c:f>
              <c:numCache>
                <c:formatCode>General</c:formatCode>
                <c:ptCount val="5"/>
                <c:pt idx="0">
                  <c:v>1.0096421753184428</c:v>
                </c:pt>
                <c:pt idx="1">
                  <c:v>5.0555259751355566</c:v>
                </c:pt>
                <c:pt idx="2">
                  <c:v>7.9539991337596696</c:v>
                </c:pt>
                <c:pt idx="3">
                  <c:v>5.1198623523802356</c:v>
                </c:pt>
                <c:pt idx="4">
                  <c:v>5.78228399852157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56-4B1B-917E-FB51F38FCB5C}"/>
            </c:ext>
          </c:extLst>
        </c:ser>
        <c:ser>
          <c:idx val="1"/>
          <c:order val="1"/>
          <c:tx>
            <c:strRef>
              <c:f>'MYB1-1'!$Q$22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B1'!$Z$43:$Z$47</c:f>
                <c:numCache>
                  <c:formatCode>General</c:formatCode>
                  <c:ptCount val="5"/>
                  <c:pt idx="0">
                    <c:v>2.4180077154602173E-2</c:v>
                  </c:pt>
                  <c:pt idx="1">
                    <c:v>0.16320246636970989</c:v>
                  </c:pt>
                  <c:pt idx="2">
                    <c:v>1.0615752161318375</c:v>
                  </c:pt>
                  <c:pt idx="3">
                    <c:v>1.054685348578966</c:v>
                  </c:pt>
                  <c:pt idx="4">
                    <c:v>0.59405512207712052</c:v>
                  </c:pt>
                </c:numCache>
              </c:numRef>
            </c:plus>
            <c:minus>
              <c:numRef>
                <c:f>'MYB1'!$Z$43:$Z$47</c:f>
                <c:numCache>
                  <c:formatCode>General</c:formatCode>
                  <c:ptCount val="5"/>
                  <c:pt idx="0">
                    <c:v>2.4180077154602173E-2</c:v>
                  </c:pt>
                  <c:pt idx="1">
                    <c:v>0.16320246636970989</c:v>
                  </c:pt>
                  <c:pt idx="2">
                    <c:v>1.0615752161318375</c:v>
                  </c:pt>
                  <c:pt idx="3">
                    <c:v>1.054685348578966</c:v>
                  </c:pt>
                  <c:pt idx="4">
                    <c:v>0.594055122077120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B1-1'!$O$23:$O$27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'MYB1-1'!$Q$23:$Q$27</c:f>
              <c:numCache>
                <c:formatCode>General</c:formatCode>
                <c:ptCount val="5"/>
                <c:pt idx="0">
                  <c:v>1.0045182151645184</c:v>
                </c:pt>
                <c:pt idx="1">
                  <c:v>9.8670010944402247</c:v>
                </c:pt>
                <c:pt idx="2">
                  <c:v>12.47162513380348</c:v>
                </c:pt>
                <c:pt idx="3">
                  <c:v>13.740021690020631</c:v>
                </c:pt>
                <c:pt idx="4">
                  <c:v>14.9399521205319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A56-4B1B-917E-FB51F38FCB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  <c:max val="2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407544150526844"/>
          <c:y val="5.5820343949660609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ea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HLH1!$U$72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HLH1!$W$73:$W$77</c:f>
                <c:numCache>
                  <c:formatCode>General</c:formatCode>
                  <c:ptCount val="5"/>
                  <c:pt idx="0">
                    <c:v>0.1158758982186309</c:v>
                  </c:pt>
                  <c:pt idx="1">
                    <c:v>0.39344515810801212</c:v>
                  </c:pt>
                  <c:pt idx="2">
                    <c:v>0.32024353732649186</c:v>
                  </c:pt>
                  <c:pt idx="3">
                    <c:v>0.1345481123249222</c:v>
                  </c:pt>
                  <c:pt idx="4">
                    <c:v>0.19043262535738903</c:v>
                  </c:pt>
                </c:numCache>
              </c:numRef>
            </c:plus>
            <c:minus>
              <c:numRef>
                <c:f>bHLH1!$W$73:$W$77</c:f>
                <c:numCache>
                  <c:formatCode>General</c:formatCode>
                  <c:ptCount val="5"/>
                  <c:pt idx="0">
                    <c:v>0.1158758982186309</c:v>
                  </c:pt>
                  <c:pt idx="1">
                    <c:v>0.39344515810801212</c:v>
                  </c:pt>
                  <c:pt idx="2">
                    <c:v>0.32024353732649186</c:v>
                  </c:pt>
                  <c:pt idx="3">
                    <c:v>0.1345481123249222</c:v>
                  </c:pt>
                  <c:pt idx="4">
                    <c:v>0.190432625357389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HLH1!$T$73:$T$77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bHLH1!$U$73:$U$77</c:f>
              <c:numCache>
                <c:formatCode>General</c:formatCode>
                <c:ptCount val="5"/>
                <c:pt idx="0">
                  <c:v>1.00431092394126</c:v>
                </c:pt>
                <c:pt idx="1">
                  <c:v>5.4607757848054641</c:v>
                </c:pt>
                <c:pt idx="2">
                  <c:v>6.1530947057425935</c:v>
                </c:pt>
                <c:pt idx="3">
                  <c:v>3.1987878793557876</c:v>
                </c:pt>
                <c:pt idx="4">
                  <c:v>3.8920185131586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1B-4E16-BFC6-D1F588473491}"/>
            </c:ext>
          </c:extLst>
        </c:ser>
        <c:ser>
          <c:idx val="1"/>
          <c:order val="1"/>
          <c:tx>
            <c:strRef>
              <c:f>bHLH1!$V$72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HLH1!$X$73:$X$77</c:f>
                <c:numCache>
                  <c:formatCode>General</c:formatCode>
                  <c:ptCount val="5"/>
                  <c:pt idx="0">
                    <c:v>3.5015092601809808E-2</c:v>
                  </c:pt>
                  <c:pt idx="1">
                    <c:v>0.87086790571066175</c:v>
                  </c:pt>
                  <c:pt idx="2">
                    <c:v>0.92739567848947457</c:v>
                  </c:pt>
                  <c:pt idx="3">
                    <c:v>0.24927117961241563</c:v>
                  </c:pt>
                  <c:pt idx="4">
                    <c:v>0.53713232628549645</c:v>
                  </c:pt>
                </c:numCache>
              </c:numRef>
            </c:plus>
            <c:minus>
              <c:numRef>
                <c:f>bHLH1!$X$73:$X$77</c:f>
                <c:numCache>
                  <c:formatCode>General</c:formatCode>
                  <c:ptCount val="5"/>
                  <c:pt idx="0">
                    <c:v>3.5015092601809808E-2</c:v>
                  </c:pt>
                  <c:pt idx="1">
                    <c:v>0.87086790571066175</c:v>
                  </c:pt>
                  <c:pt idx="2">
                    <c:v>0.92739567848947457</c:v>
                  </c:pt>
                  <c:pt idx="3">
                    <c:v>0.24927117961241563</c:v>
                  </c:pt>
                  <c:pt idx="4">
                    <c:v>0.537132326285496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HLH1!$T$73:$T$77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bHLH1!$V$73:$V$77</c:f>
              <c:numCache>
                <c:formatCode>General</c:formatCode>
                <c:ptCount val="5"/>
                <c:pt idx="0">
                  <c:v>1.0004066780819534</c:v>
                </c:pt>
                <c:pt idx="1">
                  <c:v>9.091932832401282</c:v>
                </c:pt>
                <c:pt idx="2">
                  <c:v>12.431690878322103</c:v>
                </c:pt>
                <c:pt idx="3">
                  <c:v>4.9402304780708981</c:v>
                </c:pt>
                <c:pt idx="4">
                  <c:v>5.98174931320124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91B-4E16-BFC6-D1F5884734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  <c:max val="2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00152949278243"/>
          <c:y val="4.5045935460444768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ea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W$14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W$19:$W$20</c:f>
                <c:numCache>
                  <c:formatCode>General</c:formatCode>
                  <c:ptCount val="2"/>
                  <c:pt idx="0">
                    <c:v>7.5263426266237263E-2</c:v>
                  </c:pt>
                  <c:pt idx="1">
                    <c:v>0.71695100948391144</c:v>
                  </c:pt>
                </c:numCache>
              </c:numRef>
            </c:plus>
            <c:minus>
              <c:numRef>
                <c:f>Sheet2!$W$19:$W$20</c:f>
                <c:numCache>
                  <c:formatCode>General</c:formatCode>
                  <c:ptCount val="2"/>
                  <c:pt idx="0">
                    <c:v>7.5263426266237263E-2</c:v>
                  </c:pt>
                  <c:pt idx="1">
                    <c:v>0.716951009483911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V$15:$V$16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W$15:$W$16</c:f>
              <c:numCache>
                <c:formatCode>General</c:formatCode>
                <c:ptCount val="2"/>
                <c:pt idx="0">
                  <c:v>2.4116666666666666</c:v>
                </c:pt>
                <c:pt idx="1">
                  <c:v>15.87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A7-4686-A685-FD084CBB6BBE}"/>
            </c:ext>
          </c:extLst>
        </c:ser>
        <c:ser>
          <c:idx val="1"/>
          <c:order val="1"/>
          <c:tx>
            <c:strRef>
              <c:f>Sheet2!$X$14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X$19:$X$20</c:f>
                <c:numCache>
                  <c:formatCode>General</c:formatCode>
                  <c:ptCount val="2"/>
                  <c:pt idx="0">
                    <c:v>0.12515823318237329</c:v>
                  </c:pt>
                  <c:pt idx="1">
                    <c:v>0.50784060819644383</c:v>
                  </c:pt>
                </c:numCache>
              </c:numRef>
            </c:plus>
            <c:minus>
              <c:numRef>
                <c:f>Sheet2!$X$19:$X$20</c:f>
                <c:numCache>
                  <c:formatCode>General</c:formatCode>
                  <c:ptCount val="2"/>
                  <c:pt idx="0">
                    <c:v>0.12515823318237329</c:v>
                  </c:pt>
                  <c:pt idx="1">
                    <c:v>0.507840608196443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V$15:$V$16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X$15:$X$16</c:f>
              <c:numCache>
                <c:formatCode>General</c:formatCode>
                <c:ptCount val="2"/>
                <c:pt idx="0">
                  <c:v>2.5783333333333331</c:v>
                </c:pt>
                <c:pt idx="1">
                  <c:v>12.8491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FA7-4686-A685-FD084CBB6B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20778576"/>
        <c:axId val="920782896"/>
      </c:barChart>
      <c:catAx>
        <c:axId val="920778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82896"/>
        <c:crosses val="autoZero"/>
        <c:auto val="1"/>
        <c:lblAlgn val="ctr"/>
        <c:lblOffset val="100"/>
        <c:noMultiLvlLbl val="0"/>
      </c:catAx>
      <c:valAx>
        <c:axId val="920782896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7857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612266352180413"/>
          <c:y val="4.065217847769028E-2"/>
          <c:w val="0.19339204036493085"/>
          <c:h val="9.00006299212598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C$31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35:$D$35</c:f>
                <c:numCache>
                  <c:formatCode>General</c:formatCode>
                  <c:ptCount val="2"/>
                  <c:pt idx="0">
                    <c:v>0.51341381944782227</c:v>
                  </c:pt>
                  <c:pt idx="1">
                    <c:v>0.82745971704569088</c:v>
                  </c:pt>
                </c:numCache>
              </c:numRef>
            </c:plus>
            <c:minus>
              <c:numRef>
                <c:f>Sheet2!$C$35:$D$35</c:f>
                <c:numCache>
                  <c:formatCode>General</c:formatCode>
                  <c:ptCount val="2"/>
                  <c:pt idx="0">
                    <c:v>0.51341381944782227</c:v>
                  </c:pt>
                  <c:pt idx="1">
                    <c:v>0.827459717045690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2:$B$33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C$32:$C$33</c:f>
              <c:numCache>
                <c:formatCode>General</c:formatCode>
                <c:ptCount val="2"/>
                <c:pt idx="0">
                  <c:v>40.792499999999997</c:v>
                </c:pt>
                <c:pt idx="1">
                  <c:v>27.771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46-41C4-A318-5654EC02BE71}"/>
            </c:ext>
          </c:extLst>
        </c:ser>
        <c:ser>
          <c:idx val="1"/>
          <c:order val="1"/>
          <c:tx>
            <c:strRef>
              <c:f>Sheet2!$D$31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36:$D$36</c:f>
                <c:numCache>
                  <c:formatCode>General</c:formatCode>
                  <c:ptCount val="2"/>
                  <c:pt idx="0">
                    <c:v>8.0829037686548075E-2</c:v>
                  </c:pt>
                  <c:pt idx="1">
                    <c:v>0.3178082493160525</c:v>
                  </c:pt>
                </c:numCache>
              </c:numRef>
            </c:plus>
            <c:minus>
              <c:numRef>
                <c:f>Sheet2!$C$36:$D$36</c:f>
                <c:numCache>
                  <c:formatCode>General</c:formatCode>
                  <c:ptCount val="2"/>
                  <c:pt idx="0">
                    <c:v>8.0829037686548075E-2</c:v>
                  </c:pt>
                  <c:pt idx="1">
                    <c:v>0.31780824931605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32:$B$33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D$32:$D$33</c:f>
              <c:numCache>
                <c:formatCode>General</c:formatCode>
                <c:ptCount val="2"/>
                <c:pt idx="0">
                  <c:v>41.364166666666669</c:v>
                </c:pt>
                <c:pt idx="1">
                  <c:v>27.5291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C46-41C4-A318-5654EC02BE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20778576"/>
        <c:axId val="920782896"/>
      </c:barChart>
      <c:catAx>
        <c:axId val="920778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82896"/>
        <c:crosses val="autoZero"/>
        <c:auto val="1"/>
        <c:lblAlgn val="ctr"/>
        <c:lblOffset val="100"/>
        <c:noMultiLvlLbl val="0"/>
      </c:catAx>
      <c:valAx>
        <c:axId val="920782896"/>
        <c:scaling>
          <c:orientation val="minMax"/>
          <c:max val="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7857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934580172303391"/>
          <c:y val="4.5985511811023623E-2"/>
          <c:w val="0.19339204036493085"/>
          <c:h val="9.00006299212598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F$31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35:$G$35</c:f>
                <c:numCache>
                  <c:formatCode>General</c:formatCode>
                  <c:ptCount val="2"/>
                  <c:pt idx="0">
                    <c:v>1.061644753829327</c:v>
                  </c:pt>
                  <c:pt idx="1">
                    <c:v>0.37466929862657944</c:v>
                  </c:pt>
                </c:numCache>
              </c:numRef>
            </c:plus>
            <c:minus>
              <c:numRef>
                <c:f>Sheet2!$F$35:$G$35</c:f>
                <c:numCache>
                  <c:formatCode>General</c:formatCode>
                  <c:ptCount val="2"/>
                  <c:pt idx="0">
                    <c:v>1.061644753829327</c:v>
                  </c:pt>
                  <c:pt idx="1">
                    <c:v>0.374669298626579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E$32:$E$33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F$32:$F$33</c:f>
              <c:numCache>
                <c:formatCode>General</c:formatCode>
                <c:ptCount val="2"/>
                <c:pt idx="0">
                  <c:v>24.834166666666665</c:v>
                </c:pt>
                <c:pt idx="1">
                  <c:v>20.8241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D1-4B5B-A1DD-509FFBCF0C6E}"/>
            </c:ext>
          </c:extLst>
        </c:ser>
        <c:ser>
          <c:idx val="1"/>
          <c:order val="1"/>
          <c:tx>
            <c:strRef>
              <c:f>Sheet2!$G$31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F$36:$G$36</c:f>
                <c:numCache>
                  <c:formatCode>General</c:formatCode>
                  <c:ptCount val="2"/>
                  <c:pt idx="0">
                    <c:v>1.105085780984143</c:v>
                  </c:pt>
                  <c:pt idx="1">
                    <c:v>0.43862711954460881</c:v>
                  </c:pt>
                </c:numCache>
              </c:numRef>
            </c:plus>
            <c:minus>
              <c:numRef>
                <c:f>Sheet2!$F$36:$G$36</c:f>
                <c:numCache>
                  <c:formatCode>General</c:formatCode>
                  <c:ptCount val="2"/>
                  <c:pt idx="0">
                    <c:v>1.105085780984143</c:v>
                  </c:pt>
                  <c:pt idx="1">
                    <c:v>0.438627119544608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E$32:$E$33</c:f>
              <c:strCache>
                <c:ptCount val="2"/>
                <c:pt idx="0">
                  <c:v>CK</c:v>
                </c:pt>
                <c:pt idx="1">
                  <c:v>Salt</c:v>
                </c:pt>
              </c:strCache>
            </c:strRef>
          </c:cat>
          <c:val>
            <c:numRef>
              <c:f>Sheet2!$G$32:$G$33</c:f>
              <c:numCache>
                <c:formatCode>General</c:formatCode>
                <c:ptCount val="2"/>
                <c:pt idx="0">
                  <c:v>28.748333333333335</c:v>
                </c:pt>
                <c:pt idx="1">
                  <c:v>24.34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9D1-4B5B-A1DD-509FFBCF0C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20778576"/>
        <c:axId val="920782896"/>
      </c:barChart>
      <c:catAx>
        <c:axId val="920778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82896"/>
        <c:crosses val="autoZero"/>
        <c:auto val="1"/>
        <c:lblAlgn val="ctr"/>
        <c:lblOffset val="100"/>
        <c:noMultiLvlLbl val="0"/>
      </c:catAx>
      <c:valAx>
        <c:axId val="920782896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2077857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849181258683107"/>
          <c:y val="2.4652178477690283E-2"/>
          <c:w val="0.19339204036493085"/>
          <c:h val="9.00006299212598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LS!$S$43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LS!$U$44:$U$48</c:f>
                <c:numCache>
                  <c:formatCode>General</c:formatCode>
                  <c:ptCount val="5"/>
                  <c:pt idx="0">
                    <c:v>0.15537132866225589</c:v>
                  </c:pt>
                  <c:pt idx="1">
                    <c:v>0.63285687392061851</c:v>
                  </c:pt>
                  <c:pt idx="2">
                    <c:v>9.1595534760371272E-2</c:v>
                  </c:pt>
                  <c:pt idx="3">
                    <c:v>0.5035296491010457</c:v>
                  </c:pt>
                  <c:pt idx="4">
                    <c:v>0.33928962151531528</c:v>
                  </c:pt>
                </c:numCache>
              </c:numRef>
            </c:plus>
            <c:minus>
              <c:numRef>
                <c:f>FLS!$U$44:$U$48</c:f>
                <c:numCache>
                  <c:formatCode>General</c:formatCode>
                  <c:ptCount val="5"/>
                  <c:pt idx="0">
                    <c:v>0.15537132866225589</c:v>
                  </c:pt>
                  <c:pt idx="1">
                    <c:v>0.63285687392061851</c:v>
                  </c:pt>
                  <c:pt idx="2">
                    <c:v>9.1595534760371272E-2</c:v>
                  </c:pt>
                  <c:pt idx="3">
                    <c:v>0.5035296491010457</c:v>
                  </c:pt>
                  <c:pt idx="4">
                    <c:v>0.339289621515315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LS!$R$44:$R$48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FLS!$S$44:$S$48</c:f>
              <c:numCache>
                <c:formatCode>General</c:formatCode>
                <c:ptCount val="5"/>
                <c:pt idx="0">
                  <c:v>1.0081485406583361</c:v>
                </c:pt>
                <c:pt idx="1">
                  <c:v>7.8348455594612636</c:v>
                </c:pt>
                <c:pt idx="2">
                  <c:v>3.5153368584833196</c:v>
                </c:pt>
                <c:pt idx="3">
                  <c:v>4.3174979742375532</c:v>
                </c:pt>
                <c:pt idx="4">
                  <c:v>4.4471750002183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B2-42C7-8823-912BE3047351}"/>
            </c:ext>
          </c:extLst>
        </c:ser>
        <c:ser>
          <c:idx val="1"/>
          <c:order val="1"/>
          <c:tx>
            <c:strRef>
              <c:f>FLS!$T$43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LS!$V$44:$V$48</c:f>
                <c:numCache>
                  <c:formatCode>General</c:formatCode>
                  <c:ptCount val="5"/>
                  <c:pt idx="0">
                    <c:v>0.17950513803730006</c:v>
                  </c:pt>
                  <c:pt idx="1">
                    <c:v>0.36016297516795237</c:v>
                  </c:pt>
                  <c:pt idx="2">
                    <c:v>1.0908992126796424</c:v>
                  </c:pt>
                  <c:pt idx="3">
                    <c:v>1.0521606337469949</c:v>
                  </c:pt>
                  <c:pt idx="4">
                    <c:v>0.47481579512609651</c:v>
                  </c:pt>
                </c:numCache>
              </c:numRef>
            </c:plus>
            <c:minus>
              <c:numRef>
                <c:f>FLS!$V$44:$V$48</c:f>
                <c:numCache>
                  <c:formatCode>General</c:formatCode>
                  <c:ptCount val="5"/>
                  <c:pt idx="0">
                    <c:v>0.17950513803730006</c:v>
                  </c:pt>
                  <c:pt idx="1">
                    <c:v>0.36016297516795237</c:v>
                  </c:pt>
                  <c:pt idx="2">
                    <c:v>1.0908992126796424</c:v>
                  </c:pt>
                  <c:pt idx="3">
                    <c:v>1.0521606337469949</c:v>
                  </c:pt>
                  <c:pt idx="4">
                    <c:v>0.474815795126096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LS!$R$44:$R$48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FLS!$T$44:$T$48</c:f>
              <c:numCache>
                <c:formatCode>General</c:formatCode>
                <c:ptCount val="5"/>
                <c:pt idx="0">
                  <c:v>1.0100147375702233</c:v>
                </c:pt>
                <c:pt idx="1">
                  <c:v>10.107022276851289</c:v>
                </c:pt>
                <c:pt idx="2">
                  <c:v>10.212247153283391</c:v>
                </c:pt>
                <c:pt idx="3">
                  <c:v>10.589787265616755</c:v>
                </c:pt>
                <c:pt idx="4">
                  <c:v>9.78879936459578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B2-42C7-8823-912BE30473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  <c:max val="1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363854166666667"/>
          <c:y val="6.663504273504274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HLH2!$S$45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HLH2!$U$46:$U$50</c:f>
                <c:numCache>
                  <c:formatCode>General</c:formatCode>
                  <c:ptCount val="5"/>
                  <c:pt idx="0">
                    <c:v>0.20834724651883008</c:v>
                  </c:pt>
                  <c:pt idx="1">
                    <c:v>0.13482779105072704</c:v>
                  </c:pt>
                  <c:pt idx="2">
                    <c:v>3.3797029396603707E-2</c:v>
                  </c:pt>
                  <c:pt idx="3">
                    <c:v>0.38445567794856028</c:v>
                  </c:pt>
                  <c:pt idx="4">
                    <c:v>0.10352190247474731</c:v>
                  </c:pt>
                </c:numCache>
              </c:numRef>
            </c:plus>
            <c:minus>
              <c:numRef>
                <c:f>bHLH2!$U$46:$U$50</c:f>
                <c:numCache>
                  <c:formatCode>General</c:formatCode>
                  <c:ptCount val="5"/>
                  <c:pt idx="0">
                    <c:v>0.20834724651883008</c:v>
                  </c:pt>
                  <c:pt idx="1">
                    <c:v>0.13482779105072704</c:v>
                  </c:pt>
                  <c:pt idx="2">
                    <c:v>3.3797029396603707E-2</c:v>
                  </c:pt>
                  <c:pt idx="3">
                    <c:v>0.38445567794856028</c:v>
                  </c:pt>
                  <c:pt idx="4">
                    <c:v>0.103521902474747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HLH2!$R$46:$R$50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bHLH2!$S$46:$S$50</c:f>
              <c:numCache>
                <c:formatCode>General</c:formatCode>
                <c:ptCount val="5"/>
                <c:pt idx="0">
                  <c:v>1.0154310767177062</c:v>
                </c:pt>
                <c:pt idx="1">
                  <c:v>1.1859063271649377</c:v>
                </c:pt>
                <c:pt idx="2">
                  <c:v>1.0795801092190189</c:v>
                </c:pt>
                <c:pt idx="3">
                  <c:v>4.5737301881973069</c:v>
                </c:pt>
                <c:pt idx="4">
                  <c:v>4.12282905009057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08-49FF-AEB9-64211C802E14}"/>
            </c:ext>
          </c:extLst>
        </c:ser>
        <c:ser>
          <c:idx val="1"/>
          <c:order val="1"/>
          <c:tx>
            <c:strRef>
              <c:f>bHLH2!$T$45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HLH2!$V$46:$V$50</c:f>
                <c:numCache>
                  <c:formatCode>General</c:formatCode>
                  <c:ptCount val="5"/>
                  <c:pt idx="0">
                    <c:v>8.6952207421625988E-2</c:v>
                  </c:pt>
                  <c:pt idx="1">
                    <c:v>0.20252361604734309</c:v>
                  </c:pt>
                  <c:pt idx="2">
                    <c:v>0.83694928931439483</c:v>
                  </c:pt>
                  <c:pt idx="3">
                    <c:v>0.80931834425904159</c:v>
                  </c:pt>
                  <c:pt idx="4">
                    <c:v>0.25584825972968606</c:v>
                  </c:pt>
                </c:numCache>
              </c:numRef>
            </c:plus>
            <c:minus>
              <c:numRef>
                <c:f>bHLH2!$V$46:$V$50</c:f>
                <c:numCache>
                  <c:formatCode>General</c:formatCode>
                  <c:ptCount val="5"/>
                  <c:pt idx="0">
                    <c:v>8.6952207421625988E-2</c:v>
                  </c:pt>
                  <c:pt idx="1">
                    <c:v>0.20252361604734309</c:v>
                  </c:pt>
                  <c:pt idx="2">
                    <c:v>0.83694928931439483</c:v>
                  </c:pt>
                  <c:pt idx="3">
                    <c:v>0.80931834425904159</c:v>
                  </c:pt>
                  <c:pt idx="4">
                    <c:v>0.255848259729686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HLH2!$R$46:$R$50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bHLH2!$T$46:$T$50</c:f>
              <c:numCache>
                <c:formatCode>General</c:formatCode>
                <c:ptCount val="5"/>
                <c:pt idx="0">
                  <c:v>1.0025081536876272</c:v>
                </c:pt>
                <c:pt idx="1">
                  <c:v>2.1599337320565746</c:v>
                </c:pt>
                <c:pt idx="2">
                  <c:v>6.5923391196088739</c:v>
                </c:pt>
                <c:pt idx="3">
                  <c:v>11.6236338194431</c:v>
                </c:pt>
                <c:pt idx="4">
                  <c:v>8.40030296806267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08-49FF-AEB9-64211C802E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  <c:max val="1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214564070172977"/>
          <c:y val="7.7369017221499525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 algn="ctr">
        <a:defRPr lang="en-US" altLang="zh-CN" sz="900" b="1" i="0" u="none" strike="noStrike" kern="1200" baseline="0">
          <a:solidFill>
            <a:schemeClr val="tx1">
              <a:lumMod val="65000"/>
              <a:lumOff val="35000"/>
            </a:schemeClr>
          </a:solidFill>
          <a:latin typeface="+mn-ea"/>
          <a:ea typeface="+mn-ea"/>
          <a:cs typeface="+mn-cs"/>
        </a:defRPr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R$37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T$38:$T$42</c:f>
                <c:numCache>
                  <c:formatCode>General</c:formatCode>
                  <c:ptCount val="5"/>
                  <c:pt idx="0">
                    <c:v>2.1247758186183806E-2</c:v>
                  </c:pt>
                  <c:pt idx="1">
                    <c:v>8.7358828056329288E-2</c:v>
                  </c:pt>
                  <c:pt idx="2">
                    <c:v>0.62880373080872631</c:v>
                  </c:pt>
                  <c:pt idx="3">
                    <c:v>7.1446647127839746</c:v>
                  </c:pt>
                  <c:pt idx="4">
                    <c:v>4.0548591415016029</c:v>
                  </c:pt>
                </c:numCache>
              </c:numRef>
            </c:plus>
            <c:minus>
              <c:numRef>
                <c:f>Sheet2!$T$38:$T$42</c:f>
                <c:numCache>
                  <c:formatCode>General</c:formatCode>
                  <c:ptCount val="5"/>
                  <c:pt idx="0">
                    <c:v>2.1247758186183806E-2</c:v>
                  </c:pt>
                  <c:pt idx="1">
                    <c:v>8.7358828056329288E-2</c:v>
                  </c:pt>
                  <c:pt idx="2">
                    <c:v>0.62880373080872631</c:v>
                  </c:pt>
                  <c:pt idx="3">
                    <c:v>7.1446647127839746</c:v>
                  </c:pt>
                  <c:pt idx="4">
                    <c:v>4.05485914150160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Q$38:$Q$42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Sheet2!$R$38:$R$42</c:f>
              <c:numCache>
                <c:formatCode>General</c:formatCode>
                <c:ptCount val="5"/>
                <c:pt idx="0">
                  <c:v>1.0001498087822529</c:v>
                </c:pt>
                <c:pt idx="1">
                  <c:v>2.4406706925076826</c:v>
                </c:pt>
                <c:pt idx="2">
                  <c:v>5.0205071579357616</c:v>
                </c:pt>
                <c:pt idx="3">
                  <c:v>117.65954704733785</c:v>
                </c:pt>
                <c:pt idx="4">
                  <c:v>280.15866948732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39-46C3-B8D9-5FA398495561}"/>
            </c:ext>
          </c:extLst>
        </c:ser>
        <c:ser>
          <c:idx val="1"/>
          <c:order val="1"/>
          <c:tx>
            <c:strRef>
              <c:f>Sheet2!$S$37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U$38:$U$42</c:f>
                <c:numCache>
                  <c:formatCode>General</c:formatCode>
                  <c:ptCount val="5"/>
                  <c:pt idx="0">
                    <c:v>3.0466346743989868E-2</c:v>
                  </c:pt>
                  <c:pt idx="1">
                    <c:v>3.8689072434463193E-2</c:v>
                  </c:pt>
                  <c:pt idx="2">
                    <c:v>0.30262589930588102</c:v>
                  </c:pt>
                  <c:pt idx="3">
                    <c:v>28.817750528177793</c:v>
                  </c:pt>
                  <c:pt idx="4">
                    <c:v>15.644818111199823</c:v>
                  </c:pt>
                </c:numCache>
              </c:numRef>
            </c:plus>
            <c:minus>
              <c:numRef>
                <c:f>Sheet2!$U$38:$U$42</c:f>
                <c:numCache>
                  <c:formatCode>General</c:formatCode>
                  <c:ptCount val="5"/>
                  <c:pt idx="0">
                    <c:v>3.0466346743989868E-2</c:v>
                  </c:pt>
                  <c:pt idx="1">
                    <c:v>3.8689072434463193E-2</c:v>
                  </c:pt>
                  <c:pt idx="2">
                    <c:v>0.30262589930588102</c:v>
                  </c:pt>
                  <c:pt idx="3">
                    <c:v>28.817750528177793</c:v>
                  </c:pt>
                  <c:pt idx="4">
                    <c:v>15.6448181111998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Q$38:$Q$42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Sheet2!$S$38:$S$42</c:f>
              <c:numCache>
                <c:formatCode>General</c:formatCode>
                <c:ptCount val="5"/>
                <c:pt idx="0">
                  <c:v>1.0003059753072208</c:v>
                </c:pt>
                <c:pt idx="1">
                  <c:v>2.2142423892885135</c:v>
                </c:pt>
                <c:pt idx="2">
                  <c:v>12.411612073500336</c:v>
                </c:pt>
                <c:pt idx="3">
                  <c:v>343.29173399231303</c:v>
                </c:pt>
                <c:pt idx="4">
                  <c:v>490.17511374061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39-46C3-B8D9-5FA3984955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600527049825027"/>
          <c:y val="4.5045935460444768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 altLang="zh-CN" sz="900" b="1" i="0" u="none" strike="noStrike" kern="1200" baseline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35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Q$36:$Q$40</c:f>
                <c:numCache>
                  <c:formatCode>General</c:formatCode>
                  <c:ptCount val="5"/>
                  <c:pt idx="0">
                    <c:v>2.4874804365844612E-2</c:v>
                  </c:pt>
                  <c:pt idx="1">
                    <c:v>0.14194070923887461</c:v>
                  </c:pt>
                  <c:pt idx="2">
                    <c:v>1.1283603159987354</c:v>
                  </c:pt>
                  <c:pt idx="3">
                    <c:v>7.0507038724689046</c:v>
                  </c:pt>
                  <c:pt idx="4">
                    <c:v>8.1734122774407751</c:v>
                  </c:pt>
                </c:numCache>
              </c:numRef>
            </c:plus>
            <c:minus>
              <c:numRef>
                <c:f>Sheet1!$Q$36:$Q$40</c:f>
                <c:numCache>
                  <c:formatCode>General</c:formatCode>
                  <c:ptCount val="5"/>
                  <c:pt idx="0">
                    <c:v>2.4874804365844612E-2</c:v>
                  </c:pt>
                  <c:pt idx="1">
                    <c:v>0.14194070923887461</c:v>
                  </c:pt>
                  <c:pt idx="2">
                    <c:v>1.1283603159987354</c:v>
                  </c:pt>
                  <c:pt idx="3">
                    <c:v>7.0507038724689046</c:v>
                  </c:pt>
                  <c:pt idx="4">
                    <c:v>8.17341227744077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36:$N$40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Sheet1!$O$36:$O$40</c:f>
              <c:numCache>
                <c:formatCode>General</c:formatCode>
                <c:ptCount val="5"/>
                <c:pt idx="0">
                  <c:v>1.0002075410587326</c:v>
                </c:pt>
                <c:pt idx="1">
                  <c:v>4.6603598647416034</c:v>
                </c:pt>
                <c:pt idx="2">
                  <c:v>17.858562152851352</c:v>
                </c:pt>
                <c:pt idx="3">
                  <c:v>59.573326121180543</c:v>
                </c:pt>
                <c:pt idx="4">
                  <c:v>117.706209621886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8F-4337-9969-A8F5C0F1470D}"/>
            </c:ext>
          </c:extLst>
        </c:ser>
        <c:ser>
          <c:idx val="1"/>
          <c:order val="1"/>
          <c:tx>
            <c:strRef>
              <c:f>Sheet1!$P$35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R$36:$R$40</c:f>
                <c:numCache>
                  <c:formatCode>General</c:formatCode>
                  <c:ptCount val="5"/>
                  <c:pt idx="0">
                    <c:v>1.057075682274726E-2</c:v>
                  </c:pt>
                  <c:pt idx="1">
                    <c:v>1.6116894874961438</c:v>
                  </c:pt>
                  <c:pt idx="2">
                    <c:v>13.555304706646067</c:v>
                  </c:pt>
                  <c:pt idx="3">
                    <c:v>3.4124998662518786</c:v>
                  </c:pt>
                  <c:pt idx="4">
                    <c:v>35.900720120285143</c:v>
                  </c:pt>
                </c:numCache>
              </c:numRef>
            </c:plus>
            <c:minus>
              <c:numRef>
                <c:f>Sheet1!$R$36:$R$40</c:f>
                <c:numCache>
                  <c:formatCode>General</c:formatCode>
                  <c:ptCount val="5"/>
                  <c:pt idx="0">
                    <c:v>1.057075682274726E-2</c:v>
                  </c:pt>
                  <c:pt idx="1">
                    <c:v>1.6116894874961438</c:v>
                  </c:pt>
                  <c:pt idx="2">
                    <c:v>13.555304706646067</c:v>
                  </c:pt>
                  <c:pt idx="3">
                    <c:v>3.4124998662518786</c:v>
                  </c:pt>
                  <c:pt idx="4">
                    <c:v>35.9007201202851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N$36:$N$40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Sheet1!$P$36:$P$40</c:f>
              <c:numCache>
                <c:formatCode>General</c:formatCode>
                <c:ptCount val="5"/>
                <c:pt idx="0">
                  <c:v>1.0000373278023142</c:v>
                </c:pt>
                <c:pt idx="1">
                  <c:v>18.341122284476935</c:v>
                </c:pt>
                <c:pt idx="2">
                  <c:v>112.21760124320629</c:v>
                </c:pt>
                <c:pt idx="3">
                  <c:v>137.21547514053429</c:v>
                </c:pt>
                <c:pt idx="4">
                  <c:v>480.84532707727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8F-4337-9969-A8F5C0F147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214564070172977"/>
          <c:y val="7.7369017221499525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 algn="ctr">
        <a:defRPr lang="en-US" altLang="zh-CN" sz="900" b="1" i="0" u="none" strike="noStrike" kern="1200" baseline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YB2'!$V$43</c:f>
              <c:strCache>
                <c:ptCount val="1"/>
                <c:pt idx="0">
                  <c:v>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B2'!$X$44:$X$48</c:f>
                <c:numCache>
                  <c:formatCode>General</c:formatCode>
                  <c:ptCount val="5"/>
                  <c:pt idx="0">
                    <c:v>1.7474600508006345E-2</c:v>
                  </c:pt>
                  <c:pt idx="1">
                    <c:v>0.26263963647906902</c:v>
                  </c:pt>
                  <c:pt idx="2">
                    <c:v>0.50616179897609903</c:v>
                  </c:pt>
                  <c:pt idx="3">
                    <c:v>0.81123953642061286</c:v>
                  </c:pt>
                  <c:pt idx="4">
                    <c:v>0.1349487233735841</c:v>
                  </c:pt>
                </c:numCache>
              </c:numRef>
            </c:plus>
            <c:minus>
              <c:numRef>
                <c:f>'MYB2'!$X$44:$X$48</c:f>
                <c:numCache>
                  <c:formatCode>General</c:formatCode>
                  <c:ptCount val="5"/>
                  <c:pt idx="0">
                    <c:v>1.7474600508006345E-2</c:v>
                  </c:pt>
                  <c:pt idx="1">
                    <c:v>0.26263963647906902</c:v>
                  </c:pt>
                  <c:pt idx="2">
                    <c:v>0.50616179897609903</c:v>
                  </c:pt>
                  <c:pt idx="3">
                    <c:v>0.81123953642061286</c:v>
                  </c:pt>
                  <c:pt idx="4">
                    <c:v>0.13494872337358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B2'!$U$44:$U$48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'MYB2'!$V$44:$V$48</c:f>
              <c:numCache>
                <c:formatCode>General</c:formatCode>
                <c:ptCount val="5"/>
                <c:pt idx="0">
                  <c:v>1.0001015466641425</c:v>
                </c:pt>
                <c:pt idx="1">
                  <c:v>4.9293405402597674</c:v>
                </c:pt>
                <c:pt idx="2">
                  <c:v>4.8404691375948499</c:v>
                </c:pt>
                <c:pt idx="3">
                  <c:v>7.4602186214429436</c:v>
                </c:pt>
                <c:pt idx="4">
                  <c:v>6.09195166061258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21-49B3-BF70-783B50AA7482}"/>
            </c:ext>
          </c:extLst>
        </c:ser>
        <c:ser>
          <c:idx val="1"/>
          <c:order val="1"/>
          <c:tx>
            <c:strRef>
              <c:f>'MYB2'!$W$43</c:f>
              <c:strCache>
                <c:ptCount val="1"/>
                <c:pt idx="0">
                  <c:v>S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B2'!$Y$44:$Y$48</c:f>
                <c:numCache>
                  <c:formatCode>General</c:formatCode>
                  <c:ptCount val="5"/>
                  <c:pt idx="0">
                    <c:v>3.8121184197609105E-2</c:v>
                  </c:pt>
                  <c:pt idx="1">
                    <c:v>2.4426314477009412</c:v>
                  </c:pt>
                  <c:pt idx="2">
                    <c:v>1.6278542957705691</c:v>
                  </c:pt>
                  <c:pt idx="3">
                    <c:v>2.6249507397670198</c:v>
                  </c:pt>
                  <c:pt idx="4">
                    <c:v>2.5203488416567583</c:v>
                  </c:pt>
                </c:numCache>
              </c:numRef>
            </c:plus>
            <c:minus>
              <c:numRef>
                <c:f>'MYB2'!$Y$44:$Y$48</c:f>
                <c:numCache>
                  <c:formatCode>General</c:formatCode>
                  <c:ptCount val="5"/>
                  <c:pt idx="0">
                    <c:v>3.8121184197609105E-2</c:v>
                  </c:pt>
                  <c:pt idx="1">
                    <c:v>2.4426314477009412</c:v>
                  </c:pt>
                  <c:pt idx="2">
                    <c:v>1.6278542957705691</c:v>
                  </c:pt>
                  <c:pt idx="3">
                    <c:v>2.6249507397670198</c:v>
                  </c:pt>
                  <c:pt idx="4">
                    <c:v>2.52034884165675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B2'!$U$44:$U$48</c:f>
              <c:strCache>
                <c:ptCount val="5"/>
                <c:pt idx="0">
                  <c:v>0h</c:v>
                </c:pt>
                <c:pt idx="1">
                  <c:v>2h</c:v>
                </c:pt>
                <c:pt idx="2">
                  <c:v>6h</c:v>
                </c:pt>
                <c:pt idx="3">
                  <c:v>12h</c:v>
                </c:pt>
                <c:pt idx="4">
                  <c:v>24h</c:v>
                </c:pt>
              </c:strCache>
            </c:strRef>
          </c:cat>
          <c:val>
            <c:numRef>
              <c:f>'MYB2'!$W$44:$W$48</c:f>
              <c:numCache>
                <c:formatCode>General</c:formatCode>
                <c:ptCount val="5"/>
                <c:pt idx="0">
                  <c:v>1.0004852911615247</c:v>
                </c:pt>
                <c:pt idx="1">
                  <c:v>7.4080384323099677</c:v>
                </c:pt>
                <c:pt idx="2">
                  <c:v>14.253197263670939</c:v>
                </c:pt>
                <c:pt idx="3">
                  <c:v>14.886480556574716</c:v>
                </c:pt>
                <c:pt idx="4">
                  <c:v>17.7495017965061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21-49B3-BF70-783B50AA74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4122936"/>
        <c:axId val="824124376"/>
      </c:barChart>
      <c:catAx>
        <c:axId val="824122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4376"/>
        <c:crosses val="autoZero"/>
        <c:auto val="1"/>
        <c:lblAlgn val="ctr"/>
        <c:lblOffset val="100"/>
        <c:noMultiLvlLbl val="0"/>
      </c:catAx>
      <c:valAx>
        <c:axId val="824124376"/>
        <c:scaling>
          <c:orientation val="minMax"/>
          <c:max val="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ea"/>
                <a:ea typeface="+mn-ea"/>
                <a:cs typeface="+mn-cs"/>
              </a:defRPr>
            </a:pPr>
            <a:endParaRPr lang="zh-CN"/>
          </a:p>
        </c:txPr>
        <c:crossAx val="82412293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407544150526844"/>
          <c:y val="5.5820343949660609E-2"/>
          <c:w val="0.17594313722208874"/>
          <c:h val="9.09097079117245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ea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A50542-E1B9-E25F-010F-854C27A79D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65B136A-7606-4314-FD42-787C58CD1A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FF9CFD-88CD-719F-F9FC-3315CB9D9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EFF4C7-2347-C3C9-C127-923936096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A51F1A-2487-B12A-8818-0A4DFAE35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801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EB38BD7-2B16-66E8-C62A-0F662164C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7B17CEA-5928-72FE-BD1E-C4FBDD878D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F3BED4-AD32-7543-2980-C1B733AC2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C4FA4A-3AB2-34E9-FBE6-022F177F9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788067-52F3-91D8-1728-30B45B241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52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437CA36-A315-04E9-AC5A-8E33339351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566D43-796D-95E5-294F-2213FBA5D3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2DD803-E46A-7349-34A1-ABE2D24EA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4D624C-4EE4-55E0-10A8-C836548DE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91D12F-A354-5343-ED9C-2BADE80CC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6422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62301C-91BD-FEBD-15F4-CAF4734692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0FB374-D332-DD35-516E-6E088C89D8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6C72B1-012C-D2AD-1F49-175688552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7EAC40-144F-BECC-BDB7-AE434CA10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557418-8B57-AAA3-634E-34A7A8191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205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3D100A-06C9-0A1E-A53B-CE7D6C5DF8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EFE5DE-D21B-9FC5-6F07-1E3074277B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BFA8E7-0453-3949-A2FB-7C12809FEB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69E152-1D8F-2401-3B84-E6E414C32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B0700A9-738A-2EC0-E952-D322FC820C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5976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FB28DE-9B3F-BD6F-07AC-5069344A9F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715F3B8-B660-5588-1E98-81847ABFE6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B733FA3-8AFE-D9F0-DC3A-D9D4C6D082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EF1E99-22EA-4AD5-26F4-52C5469A3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D59C1B7-E25F-893F-8137-119344B06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C5A359-31CA-D1E3-0776-FB5FC4EB2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4407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DEBC3C-4847-1CDF-F524-7B2B816271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7B29C8-C5C2-7D4B-FD81-9D4863FD4F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31D5BE8-D268-FB5B-51EE-28F84DA4B4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7F80AA4-A71A-4F92-5DD5-4F1F3B5DF5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1205E94-9418-E5D1-F39A-EB50F04A09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467980F-879A-D6C5-106C-C65E739A7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B61468B-61F9-38EF-0FFE-981D13C77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18C50BF-C42D-E3D6-8222-E4EC96E26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700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6D2076-772C-52D8-0649-FF1ADAA0B3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E71CDC4-5A6B-DC08-1562-B047D076F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5392918-CCD6-CD8B-3157-E8A883F91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12AA80C-753A-9069-4C5F-E44CE4D0A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0997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D70B6C6-F850-3F5C-F906-ACDDED3EB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5E8D6A7-52B9-8D96-6D98-212A430C9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1798517-141C-6F26-80EF-D6BE2CACD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6757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A77E59-A304-0B4A-746D-903B927E23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726CD0-A5B9-6A84-C9DA-3A71254426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7AB0CD8-0796-96A1-BD43-7DBF5D1630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1A2704E-2B21-E86A-EBD3-B2A7B3696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C0CC5AF-C16A-EAC4-0EF4-DC66E9178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761B012-C153-FFCC-2055-AE1D51D44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1139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490397-AA2B-39FC-58DF-82CDF72AA7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2CBDB3F-C1BC-1D9E-ACD3-8FF9AD097F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F93509C-4BC9-6096-1175-E05BDBBD24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2AAA1F-65AA-346F-D619-2B62D7B20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E110C3-E516-7DA1-2FF5-2B401AE78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1D27AD-B867-B38B-BF18-ADA7F72FA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5272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47F6F22-A9C3-4C9C-D8A3-94A25B8B91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1C2C6B1-845A-10E2-CDDE-186D4A53E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3BEA7E-E282-790D-E878-E2DF2430CE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85A50E-4822-4B61-841A-2891AAFDD4E5}" type="datetimeFigureOut">
              <a:rPr lang="zh-CN" altLang="en-US" smtClean="0"/>
              <a:t>2024/5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46D031-DDB7-132A-4CC9-089947BC1D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7ADE94-32C3-3204-B95E-DE79A1766B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F3797-535C-4B4F-8C66-3FA75CA738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933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1.xml"/><Relationship Id="rId3" Type="http://schemas.openxmlformats.org/officeDocument/2006/relationships/chart" Target="../charts/chart6.xml"/><Relationship Id="rId7" Type="http://schemas.openxmlformats.org/officeDocument/2006/relationships/chart" Target="../charts/chart10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9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Relationship Id="rId9" Type="http://schemas.openxmlformats.org/officeDocument/2006/relationships/chart" Target="../charts/char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C1B7E1D-0481-BBA2-B3E1-F9CCC959D793}"/>
              </a:ext>
            </a:extLst>
          </p:cNvPr>
          <p:cNvSpPr txBox="1"/>
          <p:nvPr/>
        </p:nvSpPr>
        <p:spPr>
          <a:xfrm>
            <a:off x="2444921" y="3963532"/>
            <a:ext cx="77949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alt tolerance assessment of 12</a:t>
            </a:r>
            <a:r>
              <a:rPr lang="zh-CN" altLang="en-US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gh generation soybean lines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D406DE6-6278-DF1E-351C-4A449A31A05B}"/>
              </a:ext>
            </a:extLst>
          </p:cNvPr>
          <p:cNvSpPr txBox="1"/>
          <p:nvPr/>
        </p:nvSpPr>
        <p:spPr>
          <a:xfrm>
            <a:off x="1796692" y="3518000"/>
            <a:ext cx="94809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Q07     FQ04     FQ08   FQ10   FQ02   FQ05  FQ06   FQ011   FQ09   FQ12   FQ01   FQ0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B1C6217-5D78-4E9D-78D3-57CF95D4FAA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7" t="33951" b="36820"/>
          <a:stretch/>
        </p:blipFill>
        <p:spPr>
          <a:xfrm>
            <a:off x="1357842" y="1451655"/>
            <a:ext cx="9233958" cy="2066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03656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1DB73CAA-A974-5980-D330-7269A3B84735}"/>
              </a:ext>
            </a:extLst>
          </p:cNvPr>
          <p:cNvGrpSpPr/>
          <p:nvPr/>
        </p:nvGrpSpPr>
        <p:grpSpPr>
          <a:xfrm>
            <a:off x="750806" y="1403351"/>
            <a:ext cx="10505409" cy="3606800"/>
            <a:chOff x="564540" y="1261534"/>
            <a:chExt cx="10505409" cy="36068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AC98B34-F415-C58D-1D38-F5C5F388D4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7" t="9630" r="4341" b="3457"/>
            <a:stretch/>
          </p:blipFill>
          <p:spPr>
            <a:xfrm>
              <a:off x="564540" y="1309606"/>
              <a:ext cx="4857724" cy="3423262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AC0C6A3A-D4E7-77EA-390C-AB7B1E41BF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18" t="9506" r="3421" b="3580"/>
            <a:stretch/>
          </p:blipFill>
          <p:spPr>
            <a:xfrm>
              <a:off x="5957390" y="1261534"/>
              <a:ext cx="5112559" cy="3606800"/>
            </a:xfrm>
            <a:prstGeom prst="rect">
              <a:avLst/>
            </a:prstGeom>
          </p:spPr>
        </p:pic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0679387F-74E2-50CC-9B34-D5FCBF446E53}"/>
              </a:ext>
            </a:extLst>
          </p:cNvPr>
          <p:cNvSpPr txBox="1"/>
          <p:nvPr/>
        </p:nvSpPr>
        <p:spPr>
          <a:xfrm>
            <a:off x="418451" y="5048221"/>
            <a:ext cx="1177354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0: KEGG enrichment analysis of DEGs for  SS_0 h vs SS_ 12 h (A) and for  ST_0 h vs ST_ 12 h (B) , respectively. </a:t>
            </a:r>
            <a:b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zh-CN" alt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57BC456-8164-4BAC-26EB-5DAD5059F10C}"/>
              </a:ext>
            </a:extLst>
          </p:cNvPr>
          <p:cNvSpPr txBox="1"/>
          <p:nvPr/>
        </p:nvSpPr>
        <p:spPr>
          <a:xfrm>
            <a:off x="561883" y="1451423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A</a:t>
            </a:r>
            <a:endParaRPr lang="zh-CN" altLang="en-US" sz="1598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3421B86-DD76-8141-0EFB-8F9EE92D9737}"/>
              </a:ext>
            </a:extLst>
          </p:cNvPr>
          <p:cNvSpPr txBox="1"/>
          <p:nvPr/>
        </p:nvSpPr>
        <p:spPr>
          <a:xfrm>
            <a:off x="5839913" y="1451423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B</a:t>
            </a:r>
            <a:endParaRPr lang="zh-CN" altLang="en-US" sz="1598" dirty="0"/>
          </a:p>
        </p:txBody>
      </p:sp>
    </p:spTree>
    <p:extLst>
      <p:ext uri="{BB962C8B-B14F-4D97-AF65-F5344CB8AC3E}">
        <p14:creationId xmlns:p14="http://schemas.microsoft.com/office/powerpoint/2010/main" val="23004116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2483EA5-729B-5C38-EE82-BB2814379F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9613" y="63419"/>
            <a:ext cx="11606408" cy="383230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8115372-C79E-71F0-02BA-BDC9FAB0B7CD}"/>
              </a:ext>
            </a:extLst>
          </p:cNvPr>
          <p:cNvSpPr txBox="1"/>
          <p:nvPr/>
        </p:nvSpPr>
        <p:spPr>
          <a:xfrm>
            <a:off x="372613" y="4409875"/>
            <a:ext cx="1203432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1. Eigengene expression profile for blue modules in various  samples. The heat map above shows the expression profiles of all co-expressed genes. The bar graph below illustrates the shared expression patterns of these co-expressed genes.</a:t>
            </a:r>
            <a:b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zh-CN" alt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2E95E22-23B7-2762-FAF8-98B760F0E7EF}"/>
              </a:ext>
            </a:extLst>
          </p:cNvPr>
          <p:cNvSpPr txBox="1"/>
          <p:nvPr/>
        </p:nvSpPr>
        <p:spPr>
          <a:xfrm>
            <a:off x="1165036" y="3701990"/>
            <a:ext cx="1102696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宋体" panose="02010600030101010101" pitchFamily="2" charset="-122"/>
                <a:ea typeface="宋体" panose="02010600030101010101" pitchFamily="2" charset="-122"/>
              </a:rPr>
              <a:t>SS_0h_1  SS_0h_2   SS_0h_3  SS_12h_1  SS_12h_2 SS_12h_3  SS_24h_1 SS_24h_2 SS_24h_3  ST_0h_1   ST_0h_2  ST_0h_3  ST_12h_1  ST_12h_2 ST_12h_3  ST_24h_1  ST_24h_2 ST_24h_3</a:t>
            </a:r>
            <a:endParaRPr lang="zh-CN" altLang="en-US" sz="1000" b="1" dirty="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 sz="1000" b="1" dirty="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 sz="1000" b="1" dirty="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 sz="1000" b="1" dirty="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 sz="1000" b="1" dirty="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 sz="1000" b="1" dirty="0">
              <a:latin typeface="宋体" panose="02010600030101010101" pitchFamily="2" charset="-122"/>
              <a:ea typeface="宋体" panose="02010600030101010101" pitchFamily="2" charset="-122"/>
            </a:endParaRPr>
          </a:p>
          <a:p>
            <a:endParaRPr lang="zh-CN" altLang="en-US" sz="1000" b="1" dirty="0">
              <a:latin typeface="宋体" panose="02010600030101010101" pitchFamily="2" charset="-122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042718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A04F812-2F7C-80B7-EFA3-89E2CE6085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2" t="10247" b="3086"/>
          <a:stretch/>
        </p:blipFill>
        <p:spPr>
          <a:xfrm>
            <a:off x="5736891" y="705751"/>
            <a:ext cx="6221550" cy="501877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10A462A-2EE1-D0E4-38D0-F94F2102172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28" r="3583"/>
          <a:stretch/>
        </p:blipFill>
        <p:spPr>
          <a:xfrm>
            <a:off x="562337" y="416317"/>
            <a:ext cx="5533663" cy="585883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3E5843E-FE0C-1AC0-01AB-87174D5EA9F9}"/>
              </a:ext>
            </a:extLst>
          </p:cNvPr>
          <p:cNvSpPr txBox="1"/>
          <p:nvPr/>
        </p:nvSpPr>
        <p:spPr>
          <a:xfrm>
            <a:off x="4333807" y="6275148"/>
            <a:ext cx="576182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2. </a:t>
            </a:r>
            <a:r>
              <a:rPr lang="en-US" altLang="zh-CN" sz="18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O (A)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zh-CN" altLang="en-US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EGG (B) in blue module. </a:t>
            </a:r>
            <a:br>
              <a:rPr lang="en-US" altLang="zh-CN" sz="180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9335525-6AA8-D896-ABCC-BCEB2D270F30}"/>
              </a:ext>
            </a:extLst>
          </p:cNvPr>
          <p:cNvSpPr txBox="1"/>
          <p:nvPr/>
        </p:nvSpPr>
        <p:spPr>
          <a:xfrm>
            <a:off x="1080090" y="416317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A</a:t>
            </a:r>
            <a:endParaRPr lang="zh-CN" altLang="en-US" sz="1598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85DC8F6-9E4D-7A42-2079-EC8BA55B9D53}"/>
              </a:ext>
            </a:extLst>
          </p:cNvPr>
          <p:cNvSpPr txBox="1"/>
          <p:nvPr/>
        </p:nvSpPr>
        <p:spPr>
          <a:xfrm>
            <a:off x="6835805" y="416317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B</a:t>
            </a:r>
            <a:endParaRPr lang="zh-CN" altLang="en-US" sz="1598" dirty="0"/>
          </a:p>
        </p:txBody>
      </p:sp>
    </p:spTree>
    <p:extLst>
      <p:ext uri="{BB962C8B-B14F-4D97-AF65-F5344CB8AC3E}">
        <p14:creationId xmlns:p14="http://schemas.microsoft.com/office/powerpoint/2010/main" val="14951735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图表 5">
            <a:extLst>
              <a:ext uri="{FF2B5EF4-FFF2-40B4-BE49-F238E27FC236}">
                <a16:creationId xmlns:a16="http://schemas.microsoft.com/office/drawing/2014/main" id="{36E0DE97-594B-44CC-A0C5-EC4637C8B1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2635200"/>
              </p:ext>
            </p:extLst>
          </p:nvPr>
        </p:nvGraphicFramePr>
        <p:xfrm>
          <a:off x="6428504" y="349054"/>
          <a:ext cx="288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图表 10">
            <a:extLst>
              <a:ext uri="{FF2B5EF4-FFF2-40B4-BE49-F238E27FC236}">
                <a16:creationId xmlns:a16="http://schemas.microsoft.com/office/drawing/2014/main" id="{4E513DEA-ADEB-4815-9C3C-C0B19EBE8F2A}"/>
              </a:ext>
            </a:extLst>
          </p:cNvPr>
          <p:cNvGraphicFramePr>
            <a:graphicFrameLocks/>
          </p:cNvGraphicFramePr>
          <p:nvPr/>
        </p:nvGraphicFramePr>
        <p:xfrm>
          <a:off x="9447003" y="2928497"/>
          <a:ext cx="2782016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标题 3">
            <a:extLst>
              <a:ext uri="{FF2B5EF4-FFF2-40B4-BE49-F238E27FC236}">
                <a16:creationId xmlns:a16="http://schemas.microsoft.com/office/drawing/2014/main" id="{6CEE44BA-6019-14F8-B15A-2CFEA150A595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57196" y="5643436"/>
            <a:ext cx="12221847" cy="8402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3. The effect of salt stress on the expression level of flavonoids synthesis-related genes by quantitative reverse-transcription PCR analysis. Relative expression levels of (A) </a:t>
            </a:r>
            <a:r>
              <a:rPr lang="en-US" altLang="zh-CN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E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B) </a:t>
            </a:r>
            <a:r>
              <a:rPr lang="en-US" altLang="zh-CN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81E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C) </a:t>
            </a:r>
            <a:r>
              <a:rPr lang="en-US" altLang="zh-CN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S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D) </a:t>
            </a:r>
            <a:r>
              <a:rPr lang="en-US" altLang="zh-CN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CL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E) </a:t>
            </a:r>
            <a:r>
              <a:rPr lang="en-US" altLang="zh-CN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(F) </a:t>
            </a:r>
            <a:r>
              <a:rPr lang="en-US" altLang="zh-CN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, (G) </a:t>
            </a:r>
            <a:r>
              <a:rPr lang="en-US" altLang="zh-CN" sz="18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HLH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(H) </a:t>
            </a:r>
            <a:r>
              <a:rPr lang="en-US" altLang="zh-CN" sz="18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HLH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SS and ST. </a:t>
            </a:r>
            <a:endParaRPr lang="zh-CN" altLang="en-US" sz="1800" dirty="0"/>
          </a:p>
        </p:txBody>
      </p:sp>
      <p:sp>
        <p:nvSpPr>
          <p:cNvPr id="21" name="文本框 5">
            <a:extLst>
              <a:ext uri="{FF2B5EF4-FFF2-40B4-BE49-F238E27FC236}">
                <a16:creationId xmlns:a16="http://schemas.microsoft.com/office/drawing/2014/main" id="{3817B67D-D14D-6EE4-BD77-636F7E1B823A}"/>
              </a:ext>
            </a:extLst>
          </p:cNvPr>
          <p:cNvSpPr txBox="1"/>
          <p:nvPr/>
        </p:nvSpPr>
        <p:spPr>
          <a:xfrm rot="16200000">
            <a:off x="-616757" y="1277916"/>
            <a:ext cx="1867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5">
            <a:extLst>
              <a:ext uri="{FF2B5EF4-FFF2-40B4-BE49-F238E27FC236}">
                <a16:creationId xmlns:a16="http://schemas.microsoft.com/office/drawing/2014/main" id="{1F4E0E1C-39C7-B936-C5F5-D9B017B462E0}"/>
              </a:ext>
            </a:extLst>
          </p:cNvPr>
          <p:cNvSpPr txBox="1"/>
          <p:nvPr/>
        </p:nvSpPr>
        <p:spPr>
          <a:xfrm rot="16200000">
            <a:off x="5373976" y="1187452"/>
            <a:ext cx="19594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5">
            <a:extLst>
              <a:ext uri="{FF2B5EF4-FFF2-40B4-BE49-F238E27FC236}">
                <a16:creationId xmlns:a16="http://schemas.microsoft.com/office/drawing/2014/main" id="{AC0A35DA-406E-5CCF-4734-2C72AE5E39FB}"/>
              </a:ext>
            </a:extLst>
          </p:cNvPr>
          <p:cNvSpPr txBox="1"/>
          <p:nvPr/>
        </p:nvSpPr>
        <p:spPr>
          <a:xfrm rot="16200000">
            <a:off x="8148414" y="1020876"/>
            <a:ext cx="2235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5">
            <a:extLst>
              <a:ext uri="{FF2B5EF4-FFF2-40B4-BE49-F238E27FC236}">
                <a16:creationId xmlns:a16="http://schemas.microsoft.com/office/drawing/2014/main" id="{E954810E-7D01-3253-EE86-C01DF59AA343}"/>
              </a:ext>
            </a:extLst>
          </p:cNvPr>
          <p:cNvSpPr txBox="1"/>
          <p:nvPr/>
        </p:nvSpPr>
        <p:spPr>
          <a:xfrm rot="16200000">
            <a:off x="-740977" y="3596422"/>
            <a:ext cx="2235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5">
            <a:extLst>
              <a:ext uri="{FF2B5EF4-FFF2-40B4-BE49-F238E27FC236}">
                <a16:creationId xmlns:a16="http://schemas.microsoft.com/office/drawing/2014/main" id="{4AB655C6-AFDB-BE6F-2A2D-7800B817B970}"/>
              </a:ext>
            </a:extLst>
          </p:cNvPr>
          <p:cNvSpPr txBox="1"/>
          <p:nvPr/>
        </p:nvSpPr>
        <p:spPr>
          <a:xfrm rot="16200000">
            <a:off x="2428680" y="3822728"/>
            <a:ext cx="18636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5">
            <a:extLst>
              <a:ext uri="{FF2B5EF4-FFF2-40B4-BE49-F238E27FC236}">
                <a16:creationId xmlns:a16="http://schemas.microsoft.com/office/drawing/2014/main" id="{CDBD699F-FBCE-7F06-8765-2665515924AD}"/>
              </a:ext>
            </a:extLst>
          </p:cNvPr>
          <p:cNvSpPr txBox="1"/>
          <p:nvPr/>
        </p:nvSpPr>
        <p:spPr>
          <a:xfrm rot="16200000">
            <a:off x="5247590" y="3625103"/>
            <a:ext cx="2235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5">
            <a:extLst>
              <a:ext uri="{FF2B5EF4-FFF2-40B4-BE49-F238E27FC236}">
                <a16:creationId xmlns:a16="http://schemas.microsoft.com/office/drawing/2014/main" id="{FB366FE2-E83D-0F29-7293-6224707EB34A}"/>
              </a:ext>
            </a:extLst>
          </p:cNvPr>
          <p:cNvSpPr txBox="1"/>
          <p:nvPr/>
        </p:nvSpPr>
        <p:spPr>
          <a:xfrm rot="16200000">
            <a:off x="8473606" y="3739881"/>
            <a:ext cx="1877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446A03E-9CC3-CA3B-7002-E9A36CE83833}"/>
              </a:ext>
            </a:extLst>
          </p:cNvPr>
          <p:cNvSpPr txBox="1"/>
          <p:nvPr/>
        </p:nvSpPr>
        <p:spPr>
          <a:xfrm>
            <a:off x="4180510" y="2385908"/>
            <a:ext cx="159845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15G156100</a:t>
            </a:r>
            <a:endParaRPr lang="zh-CN" altLang="en-US" sz="14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42AB7B6-A779-F113-04A1-B8FF695205B9}"/>
              </a:ext>
            </a:extLst>
          </p:cNvPr>
          <p:cNvSpPr txBox="1"/>
          <p:nvPr/>
        </p:nvSpPr>
        <p:spPr>
          <a:xfrm>
            <a:off x="7285132" y="2331465"/>
            <a:ext cx="169605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18G026500 </a:t>
            </a:r>
            <a:endParaRPr lang="zh-CN" altLang="en-US" sz="14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A2A90D69-D46C-63BC-D06D-A0A76541F008}"/>
              </a:ext>
            </a:extLst>
          </p:cNvPr>
          <p:cNvSpPr txBox="1"/>
          <p:nvPr/>
        </p:nvSpPr>
        <p:spPr>
          <a:xfrm>
            <a:off x="10183409" y="4922520"/>
            <a:ext cx="20658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08G061300</a:t>
            </a:r>
            <a:endParaRPr lang="zh-CN" altLang="en-US" sz="14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7166E11-1595-D23B-B6D2-C8216D72C35F}"/>
              </a:ext>
            </a:extLst>
          </p:cNvPr>
          <p:cNvSpPr txBox="1"/>
          <p:nvPr/>
        </p:nvSpPr>
        <p:spPr>
          <a:xfrm>
            <a:off x="70052" y="343798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A</a:t>
            </a:r>
            <a:endParaRPr lang="zh-CN" altLang="en-US" sz="1598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B11BBE2-413B-BA02-E04D-0A2310F46BDA}"/>
              </a:ext>
            </a:extLst>
          </p:cNvPr>
          <p:cNvSpPr txBox="1"/>
          <p:nvPr/>
        </p:nvSpPr>
        <p:spPr>
          <a:xfrm>
            <a:off x="8949636" y="253197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D</a:t>
            </a:r>
            <a:endParaRPr lang="zh-CN" altLang="en-US" sz="1598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2EA943EE-5DBE-4179-BB53-37B7C6555CE4}"/>
              </a:ext>
            </a:extLst>
          </p:cNvPr>
          <p:cNvSpPr txBox="1"/>
          <p:nvPr/>
        </p:nvSpPr>
        <p:spPr>
          <a:xfrm>
            <a:off x="68140" y="2901900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E</a:t>
            </a:r>
            <a:endParaRPr lang="zh-CN" altLang="en-US" sz="1598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38217AD3-40EF-0619-84F4-CD4DDE426AEA}"/>
              </a:ext>
            </a:extLst>
          </p:cNvPr>
          <p:cNvSpPr txBox="1"/>
          <p:nvPr/>
        </p:nvSpPr>
        <p:spPr>
          <a:xfrm>
            <a:off x="6136846" y="2744864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G</a:t>
            </a:r>
            <a:endParaRPr lang="zh-CN" altLang="en-US" sz="1598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70DCCB8A-1A4A-6314-36D8-6187565DFBDE}"/>
              </a:ext>
            </a:extLst>
          </p:cNvPr>
          <p:cNvSpPr txBox="1"/>
          <p:nvPr/>
        </p:nvSpPr>
        <p:spPr>
          <a:xfrm>
            <a:off x="9218314" y="2661431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H</a:t>
            </a:r>
            <a:endParaRPr lang="zh-CN" altLang="en-US" sz="1598" dirty="0"/>
          </a:p>
        </p:txBody>
      </p:sp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E6B4BB01-9CC7-44A7-82B5-4ADFC73051BC}"/>
              </a:ext>
            </a:extLst>
          </p:cNvPr>
          <p:cNvGraphicFramePr>
            <a:graphicFrameLocks/>
          </p:cNvGraphicFramePr>
          <p:nvPr/>
        </p:nvGraphicFramePr>
        <p:xfrm>
          <a:off x="3387402" y="439933"/>
          <a:ext cx="288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文本框 5">
            <a:extLst>
              <a:ext uri="{FF2B5EF4-FFF2-40B4-BE49-F238E27FC236}">
                <a16:creationId xmlns:a16="http://schemas.microsoft.com/office/drawing/2014/main" id="{DC57C9B4-87EB-C32C-183A-EE375D2BFFA2}"/>
              </a:ext>
            </a:extLst>
          </p:cNvPr>
          <p:cNvSpPr txBox="1"/>
          <p:nvPr/>
        </p:nvSpPr>
        <p:spPr>
          <a:xfrm rot="16200000">
            <a:off x="2420217" y="1277916"/>
            <a:ext cx="18674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leve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3397BD5-E2A3-6277-6EC3-1D813CFBB5CA}"/>
              </a:ext>
            </a:extLst>
          </p:cNvPr>
          <p:cNvSpPr txBox="1"/>
          <p:nvPr/>
        </p:nvSpPr>
        <p:spPr>
          <a:xfrm>
            <a:off x="4118733" y="2397694"/>
            <a:ext cx="169605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15G156100</a:t>
            </a:r>
          </a:p>
        </p:txBody>
      </p:sp>
      <p:graphicFrame>
        <p:nvGraphicFramePr>
          <p:cNvPr id="18" name="图表 17">
            <a:extLst>
              <a:ext uri="{FF2B5EF4-FFF2-40B4-BE49-F238E27FC236}">
                <a16:creationId xmlns:a16="http://schemas.microsoft.com/office/drawing/2014/main" id="{8B56B76F-A2C1-4EAF-87A2-3C576EE97F66}"/>
              </a:ext>
            </a:extLst>
          </p:cNvPr>
          <p:cNvGraphicFramePr>
            <a:graphicFrameLocks/>
          </p:cNvGraphicFramePr>
          <p:nvPr/>
        </p:nvGraphicFramePr>
        <p:xfrm>
          <a:off x="431833" y="439933"/>
          <a:ext cx="2616017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9" name="文本框 18">
            <a:extLst>
              <a:ext uri="{FF2B5EF4-FFF2-40B4-BE49-F238E27FC236}">
                <a16:creationId xmlns:a16="http://schemas.microsoft.com/office/drawing/2014/main" id="{5AA63F94-45BC-7BA7-CD68-8BF605E1384D}"/>
              </a:ext>
            </a:extLst>
          </p:cNvPr>
          <p:cNvSpPr txBox="1"/>
          <p:nvPr/>
        </p:nvSpPr>
        <p:spPr>
          <a:xfrm>
            <a:off x="2969546" y="348309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B</a:t>
            </a:r>
            <a:endParaRPr lang="zh-CN" altLang="en-US" sz="1598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6FFEC7B-6855-C0D3-0C8D-16A212D3270F}"/>
              </a:ext>
            </a:extLst>
          </p:cNvPr>
          <p:cNvSpPr txBox="1"/>
          <p:nvPr/>
        </p:nvSpPr>
        <p:spPr>
          <a:xfrm>
            <a:off x="1056049" y="2385908"/>
            <a:ext cx="169605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11G051800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E8E079E-FFE8-1F9D-1968-1838AAAC5983}"/>
              </a:ext>
            </a:extLst>
          </p:cNvPr>
          <p:cNvSpPr txBox="1"/>
          <p:nvPr/>
        </p:nvSpPr>
        <p:spPr>
          <a:xfrm>
            <a:off x="6058970" y="283556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C</a:t>
            </a:r>
            <a:endParaRPr lang="zh-CN" altLang="en-US" sz="1598" dirty="0"/>
          </a:p>
        </p:txBody>
      </p:sp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785B5E5A-676E-477E-9DC2-3AD0E059E9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2211389"/>
              </p:ext>
            </p:extLst>
          </p:nvPr>
        </p:nvGraphicFramePr>
        <p:xfrm>
          <a:off x="3470222" y="2992825"/>
          <a:ext cx="2778203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7BA91813-DDEC-93BD-777A-D3EE36B82189}"/>
              </a:ext>
            </a:extLst>
          </p:cNvPr>
          <p:cNvSpPr txBox="1"/>
          <p:nvPr/>
        </p:nvSpPr>
        <p:spPr>
          <a:xfrm>
            <a:off x="4180510" y="4990758"/>
            <a:ext cx="172684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09G032100</a:t>
            </a:r>
            <a:endParaRPr lang="zh-CN" altLang="en-US" sz="1400" dirty="0"/>
          </a:p>
        </p:txBody>
      </p:sp>
      <p:graphicFrame>
        <p:nvGraphicFramePr>
          <p:cNvPr id="12" name="图表 11">
            <a:extLst>
              <a:ext uri="{FF2B5EF4-FFF2-40B4-BE49-F238E27FC236}">
                <a16:creationId xmlns:a16="http://schemas.microsoft.com/office/drawing/2014/main" id="{004A7CAD-3B69-4CFA-83AD-B406417545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6569401"/>
              </p:ext>
            </p:extLst>
          </p:nvPr>
        </p:nvGraphicFramePr>
        <p:xfrm>
          <a:off x="9349019" y="365471"/>
          <a:ext cx="288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CCFF9AC6-5B2C-AA45-A19D-E040AF9051E2}"/>
              </a:ext>
            </a:extLst>
          </p:cNvPr>
          <p:cNvSpPr txBox="1"/>
          <p:nvPr/>
        </p:nvSpPr>
        <p:spPr>
          <a:xfrm>
            <a:off x="9989984" y="2318659"/>
            <a:ext cx="169605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17G064600</a:t>
            </a:r>
          </a:p>
        </p:txBody>
      </p:sp>
      <p:graphicFrame>
        <p:nvGraphicFramePr>
          <p:cNvPr id="7" name="图表 6">
            <a:extLst>
              <a:ext uri="{FF2B5EF4-FFF2-40B4-BE49-F238E27FC236}">
                <a16:creationId xmlns:a16="http://schemas.microsoft.com/office/drawing/2014/main" id="{0A032D5D-CF89-40A5-9E12-E38FE444E4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9233249"/>
              </p:ext>
            </p:extLst>
          </p:nvPr>
        </p:nvGraphicFramePr>
        <p:xfrm>
          <a:off x="480866" y="3015941"/>
          <a:ext cx="2697785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66C60BF4-A870-666B-E5CD-7D1F49CBC2F1}"/>
              </a:ext>
            </a:extLst>
          </p:cNvPr>
          <p:cNvSpPr txBox="1"/>
          <p:nvPr/>
        </p:nvSpPr>
        <p:spPr>
          <a:xfrm>
            <a:off x="3093950" y="2824061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F</a:t>
            </a:r>
            <a:endParaRPr lang="zh-CN" altLang="en-US" sz="1598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F0B2A48-907D-FF43-14FB-CCB0A8B44F1B}"/>
              </a:ext>
            </a:extLst>
          </p:cNvPr>
          <p:cNvSpPr txBox="1"/>
          <p:nvPr/>
        </p:nvSpPr>
        <p:spPr>
          <a:xfrm>
            <a:off x="1052375" y="4994301"/>
            <a:ext cx="172684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19G264200</a:t>
            </a:r>
            <a:endParaRPr lang="zh-CN" altLang="en-US" sz="1400" dirty="0"/>
          </a:p>
        </p:txBody>
      </p:sp>
      <p:graphicFrame>
        <p:nvGraphicFramePr>
          <p:cNvPr id="20" name="图表 19">
            <a:extLst>
              <a:ext uri="{FF2B5EF4-FFF2-40B4-BE49-F238E27FC236}">
                <a16:creationId xmlns:a16="http://schemas.microsoft.com/office/drawing/2014/main" id="{05B00BBE-3384-42BF-850A-A98279CF7D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8074135"/>
              </p:ext>
            </p:extLst>
          </p:nvPr>
        </p:nvGraphicFramePr>
        <p:xfrm>
          <a:off x="6426997" y="2958535"/>
          <a:ext cx="288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8" name="文本框 27">
            <a:extLst>
              <a:ext uri="{FF2B5EF4-FFF2-40B4-BE49-F238E27FC236}">
                <a16:creationId xmlns:a16="http://schemas.microsoft.com/office/drawing/2014/main" id="{634A7545-BCCB-D98F-87C3-BF66F30E5826}"/>
              </a:ext>
            </a:extLst>
          </p:cNvPr>
          <p:cNvSpPr txBox="1"/>
          <p:nvPr/>
        </p:nvSpPr>
        <p:spPr>
          <a:xfrm>
            <a:off x="7208017" y="4963954"/>
            <a:ext cx="206586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/>
              <a:t>Glyma.17G058600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845651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ACB87429-39A7-6B08-8DE0-C0317B84A70D}"/>
              </a:ext>
            </a:extLst>
          </p:cNvPr>
          <p:cNvSpPr txBox="1"/>
          <p:nvPr/>
        </p:nvSpPr>
        <p:spPr>
          <a:xfrm>
            <a:off x="353996" y="5300357"/>
            <a:ext cx="1198006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Effects of salt stress on Na</a:t>
            </a:r>
            <a:r>
              <a:rPr lang="en-US" altLang="zh-CN" b="0" i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K</a:t>
            </a:r>
            <a:r>
              <a:rPr lang="en-US" altLang="zh-CN" b="0" i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ontent in SS and ST. </a:t>
            </a:r>
            <a:r>
              <a:rPr lang="en-US" altLang="zh-CN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B)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a</a:t>
            </a:r>
            <a:r>
              <a:rPr lang="en-US" altLang="zh-CN" b="0" i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ontent of shoot (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and root (</a:t>
            </a:r>
            <a:r>
              <a:rPr lang="en-US" altLang="zh-CN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in SS and ST under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 and 150 mM NaCl treatment for 3 days.  </a:t>
            </a:r>
            <a:r>
              <a:rPr lang="en-US" altLang="zh-CN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D)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b="0" i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ontent of shoot (</a:t>
            </a:r>
            <a:r>
              <a:rPr lang="en-US" altLang="zh-CN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and root (</a:t>
            </a:r>
            <a:r>
              <a:rPr lang="en-US" altLang="zh-CN" b="1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in in SS and ST under 0 and 150 mM NaCl treatment for 3 days. Values with error bars represent </a:t>
            </a:r>
            <a:r>
              <a:rPr lang="en-US" altLang="zh-CN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an±SD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n=3). Statistical significance</a:t>
            </a:r>
          </a:p>
          <a:p>
            <a:r>
              <a:rPr lang="en-US" altLang="zh-CN" b="0" i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as determined using Student’s t test.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**, P≤0.01.</a:t>
            </a:r>
            <a:endParaRPr lang="zh-CN" altLang="en-US" dirty="0"/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9351DF3D-358C-C7B7-2D79-C773A7F0CFC9}"/>
              </a:ext>
            </a:extLst>
          </p:cNvPr>
          <p:cNvGrpSpPr/>
          <p:nvPr/>
        </p:nvGrpSpPr>
        <p:grpSpPr>
          <a:xfrm>
            <a:off x="2840616" y="708842"/>
            <a:ext cx="6678298" cy="4744750"/>
            <a:chOff x="2163283" y="903575"/>
            <a:chExt cx="6678298" cy="4744750"/>
          </a:xfrm>
        </p:grpSpPr>
        <p:graphicFrame>
          <p:nvGraphicFramePr>
            <p:cNvPr id="4" name="图表 3">
              <a:extLst>
                <a:ext uri="{FF2B5EF4-FFF2-40B4-BE49-F238E27FC236}">
                  <a16:creationId xmlns:a16="http://schemas.microsoft.com/office/drawing/2014/main" id="{8F492115-B59A-C643-B7FD-67E08D64629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8660474"/>
                </p:ext>
              </p:extLst>
            </p:nvPr>
          </p:nvGraphicFramePr>
          <p:xfrm>
            <a:off x="2740818" y="1047750"/>
            <a:ext cx="2881313" cy="23812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图表 4">
              <a:extLst>
                <a:ext uri="{FF2B5EF4-FFF2-40B4-BE49-F238E27FC236}">
                  <a16:creationId xmlns:a16="http://schemas.microsoft.com/office/drawing/2014/main" id="{9E10821E-B185-18D3-D9A1-76F677AEE7C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11526904"/>
                </p:ext>
              </p:extLst>
            </p:nvPr>
          </p:nvGraphicFramePr>
          <p:xfrm>
            <a:off x="5960268" y="1015525"/>
            <a:ext cx="2881313" cy="23812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BBD4C1D-7DC5-28BA-B71E-79FF2C3B9E0D}"/>
                </a:ext>
              </a:extLst>
            </p:cNvPr>
            <p:cNvSpPr txBox="1"/>
            <p:nvPr/>
          </p:nvSpPr>
          <p:spPr>
            <a:xfrm rot="16200000">
              <a:off x="1579493" y="1841764"/>
              <a:ext cx="2048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 Na</a:t>
              </a:r>
              <a:r>
                <a:rPr lang="en-US" altLang="zh-CN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ntent (mg/g) 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5">
              <a:extLst>
                <a:ext uri="{FF2B5EF4-FFF2-40B4-BE49-F238E27FC236}">
                  <a16:creationId xmlns:a16="http://schemas.microsoft.com/office/drawing/2014/main" id="{072D85E1-7836-C635-4835-8FBE88975EF0}"/>
                </a:ext>
              </a:extLst>
            </p:cNvPr>
            <p:cNvSpPr txBox="1"/>
            <p:nvPr/>
          </p:nvSpPr>
          <p:spPr>
            <a:xfrm rot="16200000">
              <a:off x="4822373" y="1773790"/>
              <a:ext cx="204820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  Na</a:t>
              </a:r>
              <a:r>
                <a:rPr lang="en-US" altLang="zh-CN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ntent (mg/g) 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8" name="图表 7">
              <a:extLst>
                <a:ext uri="{FF2B5EF4-FFF2-40B4-BE49-F238E27FC236}">
                  <a16:creationId xmlns:a16="http://schemas.microsoft.com/office/drawing/2014/main" id="{82813F42-0B70-4B39-9F84-16EBCA0F2A6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4345203"/>
                </p:ext>
              </p:extLst>
            </p:nvPr>
          </p:nvGraphicFramePr>
          <p:xfrm>
            <a:off x="2740817" y="3267075"/>
            <a:ext cx="2881313" cy="23812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9" name="图表 8">
              <a:extLst>
                <a:ext uri="{FF2B5EF4-FFF2-40B4-BE49-F238E27FC236}">
                  <a16:creationId xmlns:a16="http://schemas.microsoft.com/office/drawing/2014/main" id="{89DD532D-0F00-4CAC-9AF9-D0033EFD64E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53826325"/>
                </p:ext>
              </p:extLst>
            </p:nvPr>
          </p:nvGraphicFramePr>
          <p:xfrm>
            <a:off x="5960267" y="3257550"/>
            <a:ext cx="2881313" cy="23812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2620CF9-051B-19A5-E9A8-D45FD3D40021}"/>
                </a:ext>
              </a:extLst>
            </p:cNvPr>
            <p:cNvSpPr txBox="1"/>
            <p:nvPr/>
          </p:nvSpPr>
          <p:spPr>
            <a:xfrm rot="16200000">
              <a:off x="1532464" y="4042039"/>
              <a:ext cx="2048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  K</a:t>
              </a:r>
              <a:r>
                <a:rPr lang="en-US" altLang="zh-CN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ent (mg/g) 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5">
              <a:extLst>
                <a:ext uri="{FF2B5EF4-FFF2-40B4-BE49-F238E27FC236}">
                  <a16:creationId xmlns:a16="http://schemas.microsoft.com/office/drawing/2014/main" id="{B4D0A2EB-2A13-11A5-666A-C1EEF74EE54C}"/>
                </a:ext>
              </a:extLst>
            </p:cNvPr>
            <p:cNvSpPr txBox="1"/>
            <p:nvPr/>
          </p:nvSpPr>
          <p:spPr>
            <a:xfrm rot="16200000">
              <a:off x="4899293" y="4024078"/>
              <a:ext cx="19655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  K</a:t>
              </a:r>
              <a:r>
                <a:rPr lang="en-US" altLang="zh-CN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ntent (mg/g) 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2AF10CF5-D7E6-3A2F-FF5A-6DF83E2613ED}"/>
                </a:ext>
              </a:extLst>
            </p:cNvPr>
            <p:cNvSpPr txBox="1"/>
            <p:nvPr/>
          </p:nvSpPr>
          <p:spPr>
            <a:xfrm>
              <a:off x="2163283" y="974251"/>
              <a:ext cx="2347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</a:t>
              </a:r>
              <a:endParaRPr lang="zh-CN" altLang="en-US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142F032D-C2AC-1046-9A23-B1FDCA164E71}"/>
                </a:ext>
              </a:extLst>
            </p:cNvPr>
            <p:cNvSpPr txBox="1"/>
            <p:nvPr/>
          </p:nvSpPr>
          <p:spPr>
            <a:xfrm>
              <a:off x="5431982" y="923854"/>
              <a:ext cx="2347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B</a:t>
              </a:r>
              <a:endParaRPr lang="zh-CN" altLang="en-US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A0DAC9E-ED15-1CCB-7188-0D40753B3B69}"/>
                </a:ext>
              </a:extLst>
            </p:cNvPr>
            <p:cNvSpPr txBox="1"/>
            <p:nvPr/>
          </p:nvSpPr>
          <p:spPr>
            <a:xfrm>
              <a:off x="2163283" y="3195173"/>
              <a:ext cx="2347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C</a:t>
              </a:r>
              <a:endParaRPr lang="zh-CN" altLang="en-US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2C3D305-8C74-13FC-1759-0A137C6CD360}"/>
                </a:ext>
              </a:extLst>
            </p:cNvPr>
            <p:cNvSpPr txBox="1"/>
            <p:nvPr/>
          </p:nvSpPr>
          <p:spPr>
            <a:xfrm>
              <a:off x="5484990" y="3212109"/>
              <a:ext cx="2347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D</a:t>
              </a:r>
              <a:endParaRPr lang="zh-CN" altLang="en-US" dirty="0"/>
            </a:p>
          </p:txBody>
        </p:sp>
        <p:cxnSp>
          <p:nvCxnSpPr>
            <p:cNvPr id="2" name="直接连接符 1">
              <a:extLst>
                <a:ext uri="{FF2B5EF4-FFF2-40B4-BE49-F238E27FC236}">
                  <a16:creationId xmlns:a16="http://schemas.microsoft.com/office/drawing/2014/main" id="{1ACE0159-A845-5B39-29DD-E013EAE79501}"/>
                </a:ext>
              </a:extLst>
            </p:cNvPr>
            <p:cNvCxnSpPr/>
            <p:nvPr/>
          </p:nvCxnSpPr>
          <p:spPr>
            <a:xfrm>
              <a:off x="4598312" y="1251847"/>
              <a:ext cx="504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203D2517-1466-B35C-49E8-251B4238BE50}"/>
                </a:ext>
              </a:extLst>
            </p:cNvPr>
            <p:cNvSpPr txBox="1"/>
            <p:nvPr/>
          </p:nvSpPr>
          <p:spPr>
            <a:xfrm>
              <a:off x="4615296" y="971547"/>
              <a:ext cx="4870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86BF9931-0EE3-064E-A2CD-AD59510E971A}"/>
                </a:ext>
              </a:extLst>
            </p:cNvPr>
            <p:cNvCxnSpPr/>
            <p:nvPr/>
          </p:nvCxnSpPr>
          <p:spPr>
            <a:xfrm>
              <a:off x="7801094" y="1322799"/>
              <a:ext cx="504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BB69796F-89AF-6B5A-87BC-60C83F2BE449}"/>
                </a:ext>
              </a:extLst>
            </p:cNvPr>
            <p:cNvSpPr txBox="1"/>
            <p:nvPr/>
          </p:nvSpPr>
          <p:spPr>
            <a:xfrm>
              <a:off x="7818078" y="1042499"/>
              <a:ext cx="4870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D91F20D8-CA32-A8D6-E03F-3110E60FF97A}"/>
                </a:ext>
              </a:extLst>
            </p:cNvPr>
            <p:cNvCxnSpPr/>
            <p:nvPr/>
          </p:nvCxnSpPr>
          <p:spPr>
            <a:xfrm>
              <a:off x="7801094" y="3934156"/>
              <a:ext cx="504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1F956F16-AA7F-02CD-E627-92BB0308CFB9}"/>
                </a:ext>
              </a:extLst>
            </p:cNvPr>
            <p:cNvSpPr txBox="1"/>
            <p:nvPr/>
          </p:nvSpPr>
          <p:spPr>
            <a:xfrm>
              <a:off x="7818078" y="3653856"/>
              <a:ext cx="4870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95982022-849D-1FBA-28FD-16B9F0FCEA25}"/>
                </a:ext>
              </a:extLst>
            </p:cNvPr>
            <p:cNvCxnSpPr/>
            <p:nvPr/>
          </p:nvCxnSpPr>
          <p:spPr>
            <a:xfrm>
              <a:off x="6599115" y="3761099"/>
              <a:ext cx="504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C457878-1D9E-2C81-83E8-28235035AEEC}"/>
                </a:ext>
              </a:extLst>
            </p:cNvPr>
            <p:cNvSpPr txBox="1"/>
            <p:nvPr/>
          </p:nvSpPr>
          <p:spPr>
            <a:xfrm>
              <a:off x="6616099" y="3480799"/>
              <a:ext cx="4870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568645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69DC3A3-80F6-B9BF-BB81-443A909C63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6" t="16732" r="10785" b="26144"/>
          <a:stretch/>
        </p:blipFill>
        <p:spPr>
          <a:xfrm>
            <a:off x="8150524" y="1900945"/>
            <a:ext cx="2863965" cy="2092897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DC8D233-CF56-8AF7-432A-2C4651A667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72" t="17778" r="10797" b="24967"/>
          <a:stretch/>
        </p:blipFill>
        <p:spPr>
          <a:xfrm>
            <a:off x="5182110" y="1977771"/>
            <a:ext cx="2761740" cy="201607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16B0A29-0CFA-6EEB-30D1-C7B8CA85864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84" t="17385" r="10914" b="25490"/>
          <a:stretch/>
        </p:blipFill>
        <p:spPr>
          <a:xfrm>
            <a:off x="2111471" y="1977771"/>
            <a:ext cx="2863965" cy="2089404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43425881-8F6D-9D48-8039-CEAEFA2A7BED}"/>
              </a:ext>
            </a:extLst>
          </p:cNvPr>
          <p:cNvSpPr txBox="1"/>
          <p:nvPr/>
        </p:nvSpPr>
        <p:spPr>
          <a:xfrm>
            <a:off x="1407739" y="4240124"/>
            <a:ext cx="1031048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Venn diagrams of  significantly changed metabolites (SCMs) in SS and ST under salt stress. </a:t>
            </a:r>
            <a:b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altLang="zh-CN" sz="1800" b="0" i="0" dirty="0">
                <a:solidFill>
                  <a:srgbClr val="000000"/>
                </a:solidFill>
                <a:effectLst/>
                <a:latin typeface="TimesNewRomanPSMT"/>
              </a:rPr>
            </a:br>
            <a:br>
              <a:rPr lang="en-US" altLang="zh-CN" dirty="0"/>
            </a:b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853950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4EC7D0D1-DA00-6421-D3CF-30B28FC4CE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6936" y="361603"/>
            <a:ext cx="5872633" cy="478443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45AB793B-7391-E506-DB80-E53E71F29C23}"/>
              </a:ext>
            </a:extLst>
          </p:cNvPr>
          <p:cNvSpPr txBox="1"/>
          <p:nvPr/>
        </p:nvSpPr>
        <p:spPr>
          <a:xfrm>
            <a:off x="1405249" y="5146039"/>
            <a:ext cx="96185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Heatmap of  of significantly changed metabolites (SCMs) in SS and ST under salt stress.</a:t>
            </a:r>
          </a:p>
        </p:txBody>
      </p:sp>
    </p:spTree>
    <p:extLst>
      <p:ext uri="{BB962C8B-B14F-4D97-AF65-F5344CB8AC3E}">
        <p14:creationId xmlns:p14="http://schemas.microsoft.com/office/powerpoint/2010/main" val="41334090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F0C81ED5-8D82-8801-07D1-CC585735980B}"/>
              </a:ext>
            </a:extLst>
          </p:cNvPr>
          <p:cNvSpPr txBox="1"/>
          <p:nvPr/>
        </p:nvSpPr>
        <p:spPr>
          <a:xfrm>
            <a:off x="883286" y="6830458"/>
            <a:ext cx="1092267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  <a:t>OPLS-DA plots of 18 samples in soybean of SS_0 h vs SS_12 h (A), SS_0 h vs. SS_24 h (B), ST_0 h vs ST_12 h (C), ST_0 h vs. ST_24 h (D),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spectively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  <a:t>.</a:t>
            </a:r>
            <a:b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</a:br>
            <a:b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</a:br>
            <a:br>
              <a:rPr lang="en-US" altLang="zh-CN" dirty="0"/>
            </a:b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A355B24-E156-D48B-1B91-21542AE9C1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1250" y="94068"/>
            <a:ext cx="3877595" cy="323968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25C3F5D-8DA6-8F78-F5AC-F27680924A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4621" y="75841"/>
            <a:ext cx="3918784" cy="3257909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C5F89EC-5431-BEE3-9C47-DF1938A759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1604" y="3542229"/>
            <a:ext cx="3946463" cy="331577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9586AD4C-5C50-0F96-AA01-AB6D7B68E799}"/>
              </a:ext>
            </a:extLst>
          </p:cNvPr>
          <p:cNvSpPr txBox="1"/>
          <p:nvPr/>
        </p:nvSpPr>
        <p:spPr>
          <a:xfrm>
            <a:off x="2172818" y="101959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A</a:t>
            </a:r>
            <a:endParaRPr lang="zh-CN" altLang="en-US" sz="1598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3B0882C-E427-CC0E-C4D6-1B98BD8FF736}"/>
              </a:ext>
            </a:extLst>
          </p:cNvPr>
          <p:cNvSpPr txBox="1"/>
          <p:nvPr/>
        </p:nvSpPr>
        <p:spPr>
          <a:xfrm>
            <a:off x="6096000" y="94068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B</a:t>
            </a:r>
            <a:endParaRPr lang="zh-CN" altLang="en-US" sz="1598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F28A353-4F60-158D-EB85-BCEEBEDB925A}"/>
              </a:ext>
            </a:extLst>
          </p:cNvPr>
          <p:cNvSpPr txBox="1"/>
          <p:nvPr/>
        </p:nvSpPr>
        <p:spPr>
          <a:xfrm>
            <a:off x="2102493" y="3542229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C</a:t>
            </a:r>
            <a:endParaRPr lang="zh-CN" altLang="en-US" sz="1598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BA6ED14-2183-8402-A200-6ADA103AFB87}"/>
              </a:ext>
            </a:extLst>
          </p:cNvPr>
          <p:cNvSpPr txBox="1"/>
          <p:nvPr/>
        </p:nvSpPr>
        <p:spPr>
          <a:xfrm>
            <a:off x="6153172" y="3556507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D</a:t>
            </a:r>
            <a:endParaRPr lang="zh-CN" altLang="en-US" sz="1598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4095F8BE-FC4E-7571-4616-D3C248BFB9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86067" y="3542229"/>
            <a:ext cx="3871321" cy="3246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86595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DCF890EB-2CF8-F667-DD40-6BBD92F2F3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61" t="17361" r="10556" b="25278"/>
          <a:stretch/>
        </p:blipFill>
        <p:spPr>
          <a:xfrm>
            <a:off x="1095048" y="1129370"/>
            <a:ext cx="2990851" cy="215571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ACBA1C9-61D8-61D0-4D16-CB226798575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61" t="17362" r="9584" b="24583"/>
          <a:stretch/>
        </p:blipFill>
        <p:spPr>
          <a:xfrm>
            <a:off x="4371649" y="1190623"/>
            <a:ext cx="2991177" cy="215571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9B9E994-44D2-F054-3542-BF6B0B46344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8" t="6390" r="3473" b="16468"/>
          <a:stretch/>
        </p:blipFill>
        <p:spPr>
          <a:xfrm>
            <a:off x="7735685" y="840914"/>
            <a:ext cx="3276600" cy="273262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5D55D467-A3DA-B792-4645-7F5D5FA5E738}"/>
              </a:ext>
            </a:extLst>
          </p:cNvPr>
          <p:cNvSpPr txBox="1"/>
          <p:nvPr/>
        </p:nvSpPr>
        <p:spPr>
          <a:xfrm>
            <a:off x="999862" y="3895703"/>
            <a:ext cx="1044813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6 . Venn diagrams of  significantly changed flavonoid metabolites  in SS and ST under salt stress. </a:t>
            </a:r>
          </a:p>
          <a:p>
            <a:br>
              <a:rPr lang="en-US" altLang="zh-CN" sz="1800" b="0" i="0" dirty="0">
                <a:solidFill>
                  <a:srgbClr val="000000"/>
                </a:solidFill>
                <a:effectLst/>
                <a:latin typeface="TimesNewRomanPSMT"/>
              </a:rPr>
            </a:br>
            <a:br>
              <a:rPr lang="en-US" altLang="zh-CN" sz="1800" b="0" i="0" dirty="0">
                <a:solidFill>
                  <a:srgbClr val="000000"/>
                </a:solidFill>
                <a:effectLst/>
                <a:latin typeface="TimesNewRomanPSMT"/>
              </a:rPr>
            </a:br>
            <a:br>
              <a:rPr lang="en-US" altLang="zh-CN" dirty="0"/>
            </a:b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964000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69F91C8-F06D-31FF-86C7-A3A896BA09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4349" y="199976"/>
            <a:ext cx="4521201" cy="293746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FD78A95-36D1-B9AC-18D6-D9353D702B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6842" y="212781"/>
            <a:ext cx="4469111" cy="291185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2BB5808-C4A3-1C60-67F7-DB4AE726BE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4349" y="3214546"/>
            <a:ext cx="4422465" cy="289688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1B5B504-4ED9-0CF3-DBD8-73B01E4430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26842" y="3137441"/>
            <a:ext cx="4622158" cy="3024163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20CDADDA-B503-8F23-E687-23CC1204D492}"/>
              </a:ext>
            </a:extLst>
          </p:cNvPr>
          <p:cNvSpPr txBox="1"/>
          <p:nvPr/>
        </p:nvSpPr>
        <p:spPr>
          <a:xfrm>
            <a:off x="393699" y="6161604"/>
            <a:ext cx="1140460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7. Volcano plots for SCMs for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  <a:t>SS_0 h vs SS_12 h (A), SS_0 h vs. SS_24 h (B), ST_0 h vs ST_12 h (C), ST_0 h vs. ST_24 h (D)</a:t>
            </a:r>
            <a:r>
              <a:rPr lang="en-US" altLang="zh-CN" dirty="0">
                <a:solidFill>
                  <a:srgbClr val="000000"/>
                </a:solidFill>
                <a:latin typeface="TimesNewRomanPSMT"/>
              </a:rPr>
              <a:t>,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 </a:t>
            </a:r>
            <a:b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zh-CN" alt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B74072A-217A-FF8B-B26C-3E10361D3761}"/>
              </a:ext>
            </a:extLst>
          </p:cNvPr>
          <p:cNvSpPr txBox="1"/>
          <p:nvPr/>
        </p:nvSpPr>
        <p:spPr>
          <a:xfrm>
            <a:off x="1555119" y="139919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A</a:t>
            </a:r>
            <a:endParaRPr lang="zh-CN" altLang="en-US" sz="1598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EEC921A-3F8A-AAB5-5D5F-6C62038AFEE7}"/>
              </a:ext>
            </a:extLst>
          </p:cNvPr>
          <p:cNvSpPr txBox="1"/>
          <p:nvPr/>
        </p:nvSpPr>
        <p:spPr>
          <a:xfrm>
            <a:off x="6270875" y="135677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B</a:t>
            </a:r>
            <a:endParaRPr lang="zh-CN" altLang="en-US" sz="1598" dirty="0"/>
          </a:p>
        </p:txBody>
      </p:sp>
      <p:sp>
        <p:nvSpPr>
          <p:cNvPr id="4" name="文本框 1">
            <a:extLst>
              <a:ext uri="{FF2B5EF4-FFF2-40B4-BE49-F238E27FC236}">
                <a16:creationId xmlns:a16="http://schemas.microsoft.com/office/drawing/2014/main" id="{9586AD4C-5C50-0F96-AA01-AB6D7B68E799}"/>
              </a:ext>
            </a:extLst>
          </p:cNvPr>
          <p:cNvSpPr txBox="1"/>
          <p:nvPr/>
        </p:nvSpPr>
        <p:spPr>
          <a:xfrm>
            <a:off x="1515271" y="3066203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598" dirty="0"/>
              <a:t>C</a:t>
            </a:r>
            <a:endParaRPr lang="zh-CN" altLang="en-US" sz="1598" dirty="0"/>
          </a:p>
        </p:txBody>
      </p:sp>
      <p:sp>
        <p:nvSpPr>
          <p:cNvPr id="6" name="文本框 1">
            <a:extLst>
              <a:ext uri="{FF2B5EF4-FFF2-40B4-BE49-F238E27FC236}">
                <a16:creationId xmlns:a16="http://schemas.microsoft.com/office/drawing/2014/main" id="{9586AD4C-5C50-0F96-AA01-AB6D7B68E799}"/>
              </a:ext>
            </a:extLst>
          </p:cNvPr>
          <p:cNvSpPr txBox="1"/>
          <p:nvPr/>
        </p:nvSpPr>
        <p:spPr>
          <a:xfrm>
            <a:off x="6201334" y="3046210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598" dirty="0"/>
              <a:t>D</a:t>
            </a:r>
            <a:endParaRPr lang="zh-CN" altLang="en-US" sz="1598" dirty="0"/>
          </a:p>
        </p:txBody>
      </p:sp>
    </p:spTree>
    <p:extLst>
      <p:ext uri="{BB962C8B-B14F-4D97-AF65-F5344CB8AC3E}">
        <p14:creationId xmlns:p14="http://schemas.microsoft.com/office/powerpoint/2010/main" val="36512216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>
            <a:extLst>
              <a:ext uri="{FF2B5EF4-FFF2-40B4-BE49-F238E27FC236}">
                <a16:creationId xmlns:a16="http://schemas.microsoft.com/office/drawing/2014/main" id="{28609BB0-3A36-1B55-1639-97FEC51AB6BD}"/>
              </a:ext>
            </a:extLst>
          </p:cNvPr>
          <p:cNvGrpSpPr/>
          <p:nvPr/>
        </p:nvGrpSpPr>
        <p:grpSpPr>
          <a:xfrm>
            <a:off x="2376413" y="1843650"/>
            <a:ext cx="8449178" cy="1737249"/>
            <a:chOff x="636494" y="1633555"/>
            <a:chExt cx="8449178" cy="1737249"/>
          </a:xfrm>
        </p:grpSpPr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id="{AEB40813-36D8-F94C-4F59-12A96E2C3FA5}"/>
                </a:ext>
              </a:extLst>
            </p:cNvPr>
            <p:cNvGrpSpPr/>
            <p:nvPr/>
          </p:nvGrpSpPr>
          <p:grpSpPr>
            <a:xfrm>
              <a:off x="636494" y="1780862"/>
              <a:ext cx="2084294" cy="1517861"/>
              <a:chOff x="4419600" y="1368485"/>
              <a:chExt cx="2084294" cy="1517861"/>
            </a:xfrm>
          </p:grpSpPr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1490EB6B-3A7D-DA01-7E34-DC8D4FE849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67" t="3664" r="51893" b="15221"/>
              <a:stretch/>
            </p:blipFill>
            <p:spPr>
              <a:xfrm>
                <a:off x="4419600" y="1498305"/>
                <a:ext cx="1807494" cy="1260000"/>
              </a:xfrm>
              <a:prstGeom prst="rect">
                <a:avLst/>
              </a:prstGeom>
            </p:spPr>
          </p:pic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FD628E50-0ED4-6F91-5E26-9501BD8A8072}"/>
                  </a:ext>
                </a:extLst>
              </p:cNvPr>
              <p:cNvSpPr txBox="1"/>
              <p:nvPr/>
            </p:nvSpPr>
            <p:spPr>
              <a:xfrm>
                <a:off x="4507559" y="1368485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S_2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44836728-4E74-7EE9-F23F-046F07D3B563}"/>
                  </a:ext>
                </a:extLst>
              </p:cNvPr>
              <p:cNvSpPr txBox="1"/>
              <p:nvPr/>
            </p:nvSpPr>
            <p:spPr>
              <a:xfrm>
                <a:off x="5688106" y="2655514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T_2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</p:grpSp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79DABFC1-7221-02BB-2088-21558C5D491B}"/>
                </a:ext>
              </a:extLst>
            </p:cNvPr>
            <p:cNvGrpSpPr/>
            <p:nvPr/>
          </p:nvGrpSpPr>
          <p:grpSpPr>
            <a:xfrm>
              <a:off x="2808747" y="1803117"/>
              <a:ext cx="2085648" cy="1567687"/>
              <a:chOff x="7915836" y="1382889"/>
              <a:chExt cx="2085648" cy="1567687"/>
            </a:xfrm>
          </p:grpSpPr>
          <p:pic>
            <p:nvPicPr>
              <p:cNvPr id="63" name="图片 62">
                <a:extLst>
                  <a:ext uri="{FF2B5EF4-FFF2-40B4-BE49-F238E27FC236}">
                    <a16:creationId xmlns:a16="http://schemas.microsoft.com/office/drawing/2014/main" id="{95ECD1CA-80AD-1647-E2AE-E246793313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86" t="5549" r="51793" b="16462"/>
              <a:stretch/>
            </p:blipFill>
            <p:spPr>
              <a:xfrm>
                <a:off x="7915836" y="1498305"/>
                <a:ext cx="1887334" cy="1260000"/>
              </a:xfrm>
              <a:prstGeom prst="rect">
                <a:avLst/>
              </a:prstGeom>
            </p:spPr>
          </p:pic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95493989-4248-170F-E6B1-CF6AD2B7F67D}"/>
                  </a:ext>
                </a:extLst>
              </p:cNvPr>
              <p:cNvSpPr txBox="1"/>
              <p:nvPr/>
            </p:nvSpPr>
            <p:spPr>
              <a:xfrm>
                <a:off x="7915836" y="1382889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S_6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DC5ADEF6-8B9A-E2EF-70CD-5EFA7235DB4D}"/>
                  </a:ext>
                </a:extLst>
              </p:cNvPr>
              <p:cNvSpPr txBox="1"/>
              <p:nvPr/>
            </p:nvSpPr>
            <p:spPr>
              <a:xfrm>
                <a:off x="9185696" y="2719744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T_6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</p:grpSp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F2EC8C56-F1FB-1494-EA72-32C7EEE54435}"/>
                </a:ext>
              </a:extLst>
            </p:cNvPr>
            <p:cNvGrpSpPr/>
            <p:nvPr/>
          </p:nvGrpSpPr>
          <p:grpSpPr>
            <a:xfrm>
              <a:off x="5060840" y="1738091"/>
              <a:ext cx="1945340" cy="1560632"/>
              <a:chOff x="5060840" y="1738091"/>
              <a:chExt cx="1945340" cy="1560632"/>
            </a:xfrm>
          </p:grpSpPr>
          <p:pic>
            <p:nvPicPr>
              <p:cNvPr id="60" name="图片 59">
                <a:extLst>
                  <a:ext uri="{FF2B5EF4-FFF2-40B4-BE49-F238E27FC236}">
                    <a16:creationId xmlns:a16="http://schemas.microsoft.com/office/drawing/2014/main" id="{A88B0809-1C29-5737-47D3-B33769DA17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49" t="4076" r="51222" b="16047"/>
              <a:stretch/>
            </p:blipFill>
            <p:spPr>
              <a:xfrm>
                <a:off x="5060840" y="1876961"/>
                <a:ext cx="1859070" cy="1260000"/>
              </a:xfrm>
              <a:prstGeom prst="rect">
                <a:avLst/>
              </a:prstGeom>
            </p:spPr>
          </p:pic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12D5E5CC-B8A4-5195-E02A-10421E141D4E}"/>
                  </a:ext>
                </a:extLst>
              </p:cNvPr>
              <p:cNvSpPr txBox="1"/>
              <p:nvPr/>
            </p:nvSpPr>
            <p:spPr>
              <a:xfrm>
                <a:off x="5106769" y="1738091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S_12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0507D5BC-DC02-5577-F4DD-7258F5418106}"/>
                  </a:ext>
                </a:extLst>
              </p:cNvPr>
              <p:cNvSpPr txBox="1"/>
              <p:nvPr/>
            </p:nvSpPr>
            <p:spPr>
              <a:xfrm>
                <a:off x="6190392" y="3067891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T_12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</p:grpSp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id="{4E601D0C-3BE5-71AA-DA07-DA2ABD4D1395}"/>
                </a:ext>
              </a:extLst>
            </p:cNvPr>
            <p:cNvGrpSpPr/>
            <p:nvPr/>
          </p:nvGrpSpPr>
          <p:grpSpPr>
            <a:xfrm>
              <a:off x="7185792" y="1633555"/>
              <a:ext cx="1899880" cy="1621833"/>
              <a:chOff x="8101604" y="3666317"/>
              <a:chExt cx="1899880" cy="1621833"/>
            </a:xfrm>
          </p:grpSpPr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59AA9E79-6DC4-AED7-0B66-F14AB0525E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85" t="5549" r="51241" b="16047"/>
              <a:stretch/>
            </p:blipFill>
            <p:spPr>
              <a:xfrm>
                <a:off x="8101604" y="3845265"/>
                <a:ext cx="1899880" cy="1260000"/>
              </a:xfrm>
              <a:prstGeom prst="rect">
                <a:avLst/>
              </a:prstGeom>
            </p:spPr>
          </p:pic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C14FEA62-1C26-C3EF-E4F0-9C9E7FD59CEA}"/>
                  </a:ext>
                </a:extLst>
              </p:cNvPr>
              <p:cNvSpPr txBox="1"/>
              <p:nvPr/>
            </p:nvSpPr>
            <p:spPr>
              <a:xfrm>
                <a:off x="9185696" y="5057318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T_24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629ABDCB-CA17-1303-1FCE-DE3B1318BE9E}"/>
                  </a:ext>
                </a:extLst>
              </p:cNvPr>
              <p:cNvSpPr txBox="1"/>
              <p:nvPr/>
            </p:nvSpPr>
            <p:spPr>
              <a:xfrm>
                <a:off x="8235756" y="3666317"/>
                <a:ext cx="8157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S_24h</a:t>
                </a:r>
                <a:endParaRPr lang="zh-CN" altLang="en-US" sz="90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p:txBody>
          </p:sp>
        </p:grp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A9BB2D95-604A-C1B6-15F1-F4E1E39E8B05}"/>
              </a:ext>
            </a:extLst>
          </p:cNvPr>
          <p:cNvSpPr txBox="1"/>
          <p:nvPr/>
        </p:nvSpPr>
        <p:spPr>
          <a:xfrm>
            <a:off x="2332536" y="3879008"/>
            <a:ext cx="87467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8. Venn diagrams of DEGs for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  <a:t>SS_2 h vs. ST_2 h (A), SS_</a:t>
            </a:r>
            <a:r>
              <a:rPr lang="en-US" altLang="zh-CN" dirty="0">
                <a:solidFill>
                  <a:srgbClr val="000000"/>
                </a:solidFill>
                <a:latin typeface="TimesNewRomanPSMT"/>
              </a:rPr>
              <a:t>6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  <a:t>h vs. ST_6 h (B), SS_12 h vs ST_12 h (C), SS_</a:t>
            </a:r>
            <a:r>
              <a:rPr lang="en-US" altLang="zh-CN" dirty="0">
                <a:solidFill>
                  <a:srgbClr val="000000"/>
                </a:solidFill>
                <a:latin typeface="TimesNewRomanPSMT"/>
              </a:rPr>
              <a:t>24 </a:t>
            </a:r>
            <a:r>
              <a:rPr lang="en-US" altLang="zh-CN" b="0" i="0" dirty="0">
                <a:solidFill>
                  <a:srgbClr val="000000"/>
                </a:solidFill>
                <a:effectLst/>
                <a:latin typeface="TimesNewRomanPSMT"/>
              </a:rPr>
              <a:t>h vs. ST_24 h (D),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 </a:t>
            </a:r>
            <a:b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zh-CN" alt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A609D5F-90A7-AE1A-B527-3054D81FCAE1}"/>
              </a:ext>
            </a:extLst>
          </p:cNvPr>
          <p:cNvSpPr txBox="1"/>
          <p:nvPr/>
        </p:nvSpPr>
        <p:spPr>
          <a:xfrm>
            <a:off x="2006630" y="1900825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A</a:t>
            </a:r>
            <a:endParaRPr lang="zh-CN" altLang="en-US" sz="1598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8740596-F883-E444-80EC-E6C5B9330AC0}"/>
              </a:ext>
            </a:extLst>
          </p:cNvPr>
          <p:cNvSpPr txBox="1"/>
          <p:nvPr/>
        </p:nvSpPr>
        <p:spPr>
          <a:xfrm>
            <a:off x="4162847" y="1867104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B</a:t>
            </a:r>
            <a:endParaRPr lang="zh-CN" altLang="en-US" sz="1598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25F4F27-8ECA-28B4-0C7F-0D115E9BBBFA}"/>
              </a:ext>
            </a:extLst>
          </p:cNvPr>
          <p:cNvSpPr txBox="1"/>
          <p:nvPr/>
        </p:nvSpPr>
        <p:spPr>
          <a:xfrm>
            <a:off x="6497454" y="1867104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C</a:t>
            </a:r>
            <a:endParaRPr lang="zh-CN" altLang="en-US" sz="1598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E30FC42-7DFA-7623-65C1-1BB4772B9ACB}"/>
              </a:ext>
            </a:extLst>
          </p:cNvPr>
          <p:cNvSpPr txBox="1"/>
          <p:nvPr/>
        </p:nvSpPr>
        <p:spPr>
          <a:xfrm>
            <a:off x="8742985" y="1843650"/>
            <a:ext cx="208432" cy="3382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8" dirty="0"/>
              <a:t>D</a:t>
            </a:r>
            <a:endParaRPr lang="zh-CN" altLang="en-US" sz="1598" dirty="0"/>
          </a:p>
        </p:txBody>
      </p:sp>
    </p:spTree>
    <p:extLst>
      <p:ext uri="{BB962C8B-B14F-4D97-AF65-F5344CB8AC3E}">
        <p14:creationId xmlns:p14="http://schemas.microsoft.com/office/powerpoint/2010/main" val="39189080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E221BC4-6C69-63E1-9F79-DD26EE5BF4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12" r="24435"/>
          <a:stretch/>
        </p:blipFill>
        <p:spPr>
          <a:xfrm rot="16200000">
            <a:off x="4268053" y="-1998986"/>
            <a:ext cx="4982634" cy="970873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50C4127-CF2D-418E-12D4-504BCAC769D8}"/>
              </a:ext>
            </a:extLst>
          </p:cNvPr>
          <p:cNvSpPr txBox="1"/>
          <p:nvPr/>
        </p:nvSpPr>
        <p:spPr>
          <a:xfrm>
            <a:off x="4080934" y="5452606"/>
            <a:ext cx="576182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9. GO annotation analysis of DEGs.</a:t>
            </a:r>
            <a:b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altLang="zh-CN" dirty="0"/>
            </a:b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D6C217C2-4C68-E4CA-E0DC-2F53BFF456A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034" t="5880" r="2535" b="84536"/>
          <a:stretch/>
        </p:blipFill>
        <p:spPr>
          <a:xfrm>
            <a:off x="668869" y="1079502"/>
            <a:ext cx="1329266" cy="7535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4169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51</TotalTime>
  <Words>808</Words>
  <Application>Microsoft Office PowerPoint</Application>
  <PresentationFormat>宽屏</PresentationFormat>
  <Paragraphs>82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20" baseType="lpstr">
      <vt:lpstr>TimesNewRomanPSMT</vt:lpstr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Figure S13. The effect of salt stress on the expression level of flavonoids synthesis-related genes by quantitative reverse-transcription PCR analysis. Relative expression levels of (A) CYP81E, (B) CYP81E, (C) FLS, (D) 4CL, (E) MYB, (F) MYB , (G) bHLH and (H) bHLH in SS and ST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bin wangyubin</dc:creator>
  <cp:lastModifiedBy>yubin wangyubin</cp:lastModifiedBy>
  <cp:revision>25</cp:revision>
  <cp:lastPrinted>2024-05-21T01:52:52Z</cp:lastPrinted>
  <dcterms:created xsi:type="dcterms:W3CDTF">2024-02-22T09:33:45Z</dcterms:created>
  <dcterms:modified xsi:type="dcterms:W3CDTF">2024-05-21T05:05:46Z</dcterms:modified>
</cp:coreProperties>
</file>